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752" y="16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548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518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229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5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482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157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6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53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092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034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923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ADD62-230B-F14D-A9B9-F6298077EC1C}" type="datetimeFigureOut">
              <a:rPr lang="en-US" smtClean="0"/>
              <a:t>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64FD1-1167-1347-8A27-023053A73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52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1" Type="http://schemas.microsoft.com/office/2007/relationships/hdphoto" Target="../media/hdphoto9.wdp"/><Relationship Id="rId12" Type="http://schemas.openxmlformats.org/officeDocument/2006/relationships/image" Target="../media/image10.jpeg"/><Relationship Id="rId13" Type="http://schemas.microsoft.com/office/2007/relationships/hdphoto" Target="../media/hdphoto10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Relationship Id="rId3" Type="http://schemas.microsoft.com/office/2007/relationships/hdphoto" Target="../media/hdphoto5.wdp"/><Relationship Id="rId4" Type="http://schemas.openxmlformats.org/officeDocument/2006/relationships/image" Target="../media/image6.jpeg"/><Relationship Id="rId5" Type="http://schemas.microsoft.com/office/2007/relationships/hdphoto" Target="../media/hdphoto6.wdp"/><Relationship Id="rId6" Type="http://schemas.openxmlformats.org/officeDocument/2006/relationships/image" Target="../media/image7.jpeg"/><Relationship Id="rId7" Type="http://schemas.microsoft.com/office/2007/relationships/hdphoto" Target="../media/hdphoto7.wdp"/><Relationship Id="rId8" Type="http://schemas.openxmlformats.org/officeDocument/2006/relationships/image" Target="../media/image8.jpeg"/><Relationship Id="rId9" Type="http://schemas.microsoft.com/office/2007/relationships/hdphoto" Target="../media/hdphoto8.wdp"/><Relationship Id="rId10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0x PBS merge (RG).jpg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9723" t="14997" r="29055" b="34758"/>
          <a:stretch/>
        </p:blipFill>
        <p:spPr>
          <a:xfrm>
            <a:off x="1166500" y="886057"/>
            <a:ext cx="2300941" cy="1837766"/>
          </a:xfrm>
          <a:prstGeom prst="rect">
            <a:avLst/>
          </a:prstGeom>
        </p:spPr>
      </p:pic>
      <p:pic>
        <p:nvPicPr>
          <p:cNvPr id="5" name="Picture 4" descr="10x AM-N5 RGB 5.jpg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8777" t="49755"/>
          <a:stretch/>
        </p:blipFill>
        <p:spPr>
          <a:xfrm>
            <a:off x="3505587" y="886057"/>
            <a:ext cx="2300941" cy="1837766"/>
          </a:xfrm>
          <a:prstGeom prst="rect">
            <a:avLst/>
          </a:prstGeom>
        </p:spPr>
      </p:pic>
      <p:pic>
        <p:nvPicPr>
          <p:cNvPr id="8" name="Picture 7" descr="10x PBS+2 TGFb (merge).jpg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6345" t="1" r="2282" b="49755"/>
          <a:stretch/>
        </p:blipFill>
        <p:spPr>
          <a:xfrm>
            <a:off x="1166162" y="2820553"/>
            <a:ext cx="2300941" cy="1837766"/>
          </a:xfrm>
          <a:prstGeom prst="rect">
            <a:avLst/>
          </a:prstGeom>
        </p:spPr>
      </p:pic>
      <p:pic>
        <p:nvPicPr>
          <p:cNvPr id="9" name="Picture 8" descr="10x AM-norm5+ (merge).jpg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258" r="43369" b="49755"/>
          <a:stretch/>
        </p:blipFill>
        <p:spPr>
          <a:xfrm>
            <a:off x="3498588" y="2820552"/>
            <a:ext cx="2300941" cy="1837766"/>
          </a:xfrm>
          <a:prstGeom prst="rect">
            <a:avLst/>
          </a:prstGeom>
        </p:spPr>
      </p:pic>
      <p:cxnSp>
        <p:nvCxnSpPr>
          <p:cNvPr id="11" name="Straight Connector 10"/>
          <p:cNvCxnSpPr/>
          <p:nvPr/>
        </p:nvCxnSpPr>
        <p:spPr>
          <a:xfrm>
            <a:off x="2941533" y="2593842"/>
            <a:ext cx="410794" cy="0"/>
          </a:xfrm>
          <a:prstGeom prst="line">
            <a:avLst/>
          </a:prstGeom>
          <a:ln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261812" y="2593842"/>
            <a:ext cx="410794" cy="0"/>
          </a:xfrm>
          <a:prstGeom prst="line">
            <a:avLst/>
          </a:prstGeom>
          <a:ln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2941533" y="4491011"/>
            <a:ext cx="410794" cy="0"/>
          </a:xfrm>
          <a:prstGeom prst="line">
            <a:avLst/>
          </a:prstGeom>
          <a:ln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261812" y="4491011"/>
            <a:ext cx="410794" cy="0"/>
          </a:xfrm>
          <a:prstGeom prst="line">
            <a:avLst/>
          </a:prstGeom>
          <a:ln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080150" y="884061"/>
            <a:ext cx="748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FFFF"/>
                </a:solidFill>
                <a:latin typeface="Times New Roman"/>
                <a:cs typeface="Times New Roman"/>
              </a:rPr>
              <a:t>AM/N</a:t>
            </a:r>
            <a:endParaRPr lang="en-US" sz="1600" b="1" dirty="0">
              <a:solidFill>
                <a:srgbClr val="FFFFFF"/>
              </a:solidFill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892920" y="884061"/>
            <a:ext cx="5609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FFFF"/>
                </a:solidFill>
                <a:latin typeface="Times New Roman"/>
                <a:cs typeface="Times New Roman"/>
              </a:rPr>
              <a:t>PBS</a:t>
            </a:r>
            <a:endParaRPr lang="en-US" sz="1600" b="1" dirty="0">
              <a:solidFill>
                <a:srgbClr val="FFFFFF"/>
              </a:solidFill>
              <a:latin typeface="Times New Roman"/>
              <a:cs typeface="Times New Roman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26528" y="231827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Times New Roman"/>
                <a:cs typeface="Times New Roman"/>
              </a:rPr>
              <a:t>19%</a:t>
            </a:r>
            <a:endParaRPr lang="en-US" b="1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56892" y="234729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Times New Roman"/>
                <a:cs typeface="Times New Roman"/>
              </a:rPr>
              <a:t>21%</a:t>
            </a:r>
            <a:endParaRPr lang="en-US" b="1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34189" y="428716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Times New Roman"/>
                <a:cs typeface="Times New Roman"/>
              </a:rPr>
              <a:t>18%</a:t>
            </a:r>
            <a:endParaRPr lang="en-US" b="1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453891" y="428716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/>
                <a:cs typeface="Times New Roman"/>
              </a:rPr>
              <a:t>9</a:t>
            </a:r>
            <a:r>
              <a:rPr lang="en-US" b="1" dirty="0" smtClean="0">
                <a:solidFill>
                  <a:schemeClr val="bg1"/>
                </a:solidFill>
                <a:latin typeface="Times New Roman"/>
                <a:cs typeface="Times New Roman"/>
              </a:rPr>
              <a:t>%</a:t>
            </a:r>
            <a:endParaRPr lang="en-US" b="1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263887" y="2818556"/>
            <a:ext cx="1493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FFFF"/>
                </a:solidFill>
                <a:latin typeface="Times New Roman"/>
                <a:cs typeface="Times New Roman"/>
              </a:rPr>
              <a:t>AM/N+TGFβ1</a:t>
            </a:r>
            <a:endParaRPr lang="en-US" sz="1600" b="1" dirty="0">
              <a:solidFill>
                <a:srgbClr val="FFFFFF"/>
              </a:solidFill>
              <a:latin typeface="Times New Roman"/>
              <a:cs typeface="Times New Roman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56728" y="2820552"/>
            <a:ext cx="13103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FFFF"/>
                </a:solidFill>
                <a:latin typeface="Times New Roman"/>
                <a:cs typeface="Times New Roman"/>
              </a:rPr>
              <a:t>PBS+TGFβ1</a:t>
            </a:r>
            <a:endParaRPr lang="en-US" sz="1600" b="1" dirty="0">
              <a:solidFill>
                <a:srgbClr val="FFFFFF"/>
              </a:solidFill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54847" y="4796039"/>
            <a:ext cx="650148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Supplemental Figure S1</a:t>
            </a:r>
            <a:r>
              <a:rPr lang="en-US" dirty="0">
                <a:latin typeface="Times New Roman"/>
                <a:cs typeface="Times New Roman"/>
              </a:rPr>
              <a:t>.</a:t>
            </a:r>
            <a:r>
              <a:rPr lang="en-US" dirty="0" smtClean="0">
                <a:latin typeface="Times New Roman"/>
                <a:cs typeface="Times New Roman"/>
              </a:rPr>
              <a:t> LX-2 cells were cultured in the presence of 5 </a:t>
            </a:r>
            <a:r>
              <a:rPr lang="en-US" dirty="0">
                <a:latin typeface="Times New Roman"/>
                <a:cs typeface="Times New Roman"/>
              </a:rPr>
              <a:t>µg/mL </a:t>
            </a:r>
            <a:r>
              <a:rPr lang="en-US" dirty="0" smtClean="0">
                <a:latin typeface="Times New Roman"/>
                <a:cs typeface="Times New Roman"/>
              </a:rPr>
              <a:t>of AM/N exosomes for 5 days. Medium was removed and replaced with </a:t>
            </a:r>
            <a:r>
              <a:rPr lang="en-US" dirty="0">
                <a:latin typeface="Times New Roman"/>
                <a:cs typeface="Times New Roman"/>
              </a:rPr>
              <a:t>m</a:t>
            </a:r>
            <a:r>
              <a:rPr lang="en-US" dirty="0" smtClean="0">
                <a:latin typeface="Times New Roman"/>
                <a:cs typeface="Times New Roman"/>
              </a:rPr>
              <a:t>edium containing </a:t>
            </a:r>
            <a:r>
              <a:rPr lang="en-US" dirty="0" err="1" smtClean="0">
                <a:latin typeface="Times New Roman"/>
                <a:cs typeface="Times New Roman"/>
              </a:rPr>
              <a:t>EdU</a:t>
            </a:r>
            <a:r>
              <a:rPr lang="en-US" dirty="0" smtClean="0">
                <a:latin typeface="Times New Roman"/>
                <a:cs typeface="Times New Roman"/>
              </a:rPr>
              <a:t>.  Non</a:t>
            </a:r>
            <a:r>
              <a:rPr lang="en-US" dirty="0">
                <a:latin typeface="Times New Roman"/>
                <a:cs typeface="Times New Roman"/>
              </a:rPr>
              <a:t>-activated </a:t>
            </a:r>
            <a:r>
              <a:rPr lang="en-US" dirty="0" smtClean="0">
                <a:latin typeface="Times New Roman"/>
                <a:cs typeface="Times New Roman"/>
              </a:rPr>
              <a:t>(upper panel) </a:t>
            </a:r>
            <a:r>
              <a:rPr lang="en-US" dirty="0">
                <a:latin typeface="Times New Roman"/>
                <a:cs typeface="Times New Roman"/>
              </a:rPr>
              <a:t>and activated LX-2 cells </a:t>
            </a:r>
            <a:r>
              <a:rPr lang="en-US" dirty="0" smtClean="0">
                <a:latin typeface="Times New Roman"/>
                <a:cs typeface="Times New Roman"/>
              </a:rPr>
              <a:t>(lower panel) were then incubated at 37°C for 1h.  Cells were fixed and stained with </a:t>
            </a:r>
            <a:r>
              <a:rPr lang="en-US" dirty="0">
                <a:latin typeface="Times New Roman"/>
                <a:cs typeface="Times New Roman"/>
              </a:rPr>
              <a:t>Click-</a:t>
            </a:r>
            <a:r>
              <a:rPr lang="en-US" dirty="0" err="1">
                <a:latin typeface="Times New Roman"/>
                <a:cs typeface="Times New Roman"/>
              </a:rPr>
              <a:t>iT</a:t>
            </a:r>
            <a:r>
              <a:rPr lang="en-US" baseline="30000" dirty="0">
                <a:latin typeface="Times New Roman"/>
                <a:cs typeface="Times New Roman"/>
              </a:rPr>
              <a:t>™</a:t>
            </a:r>
            <a:r>
              <a:rPr lang="en-US" dirty="0">
                <a:latin typeface="Times New Roman"/>
                <a:cs typeface="Times New Roman"/>
              </a:rPr>
              <a:t> </a:t>
            </a:r>
            <a:r>
              <a:rPr lang="en-US" dirty="0" err="1">
                <a:latin typeface="Times New Roman"/>
                <a:cs typeface="Times New Roman"/>
              </a:rPr>
              <a:t>EdU</a:t>
            </a:r>
            <a:r>
              <a:rPr lang="en-US" dirty="0">
                <a:latin typeface="Times New Roman"/>
                <a:cs typeface="Times New Roman"/>
              </a:rPr>
              <a:t> cell proliferation kit for imaging (C10337, </a:t>
            </a:r>
            <a:r>
              <a:rPr lang="en-US" dirty="0" err="1">
                <a:latin typeface="Times New Roman"/>
                <a:cs typeface="Times New Roman"/>
              </a:rPr>
              <a:t>ThermoFisher</a:t>
            </a:r>
            <a:r>
              <a:rPr lang="en-US" dirty="0">
                <a:latin typeface="Times New Roman"/>
                <a:cs typeface="Times New Roman"/>
              </a:rPr>
              <a:t> Scientific</a:t>
            </a:r>
            <a:r>
              <a:rPr lang="en-US" dirty="0" smtClean="0">
                <a:latin typeface="Times New Roman"/>
                <a:cs typeface="Times New Roman"/>
              </a:rPr>
              <a:t>)</a:t>
            </a:r>
            <a:r>
              <a:rPr lang="en-US" dirty="0">
                <a:latin typeface="Times New Roman"/>
                <a:cs typeface="Times New Roman"/>
              </a:rPr>
              <a:t> </a:t>
            </a:r>
            <a:r>
              <a:rPr lang="en-US" dirty="0" smtClean="0">
                <a:latin typeface="Times New Roman"/>
                <a:cs typeface="Times New Roman"/>
              </a:rPr>
              <a:t>following the manufacture’s instruction.  Cells also were counter stained with DAPI.  The stained cells were examined using an </a:t>
            </a:r>
            <a:r>
              <a:rPr lang="en-US" dirty="0" err="1" smtClean="0">
                <a:latin typeface="Times New Roman"/>
                <a:cs typeface="Times New Roman"/>
              </a:rPr>
              <a:t>epi</a:t>
            </a:r>
            <a:r>
              <a:rPr lang="en-US" dirty="0" smtClean="0">
                <a:latin typeface="Times New Roman"/>
                <a:cs typeface="Times New Roman"/>
              </a:rPr>
              <a:t>-fluorescent microscope.  DAPI staining was pseudo-colored to green. Cells, which were actively proliferating and incorporating </a:t>
            </a:r>
            <a:r>
              <a:rPr lang="en-US" dirty="0" err="1" smtClean="0">
                <a:latin typeface="Times New Roman"/>
                <a:cs typeface="Times New Roman"/>
              </a:rPr>
              <a:t>EdU</a:t>
            </a:r>
            <a:r>
              <a:rPr lang="en-US" dirty="0" smtClean="0">
                <a:latin typeface="Times New Roman"/>
                <a:cs typeface="Times New Roman"/>
              </a:rPr>
              <a:t>, were shown in orange/red.  Percentages shown are Red cells/Total cells x100%. Scale bar=100</a:t>
            </a:r>
            <a:r>
              <a:rPr lang="en-US" dirty="0">
                <a:latin typeface="Times New Roman"/>
                <a:cs typeface="Times New Roman"/>
              </a:rPr>
              <a:t> </a:t>
            </a:r>
            <a:r>
              <a:rPr lang="en-US" dirty="0" err="1" smtClean="0">
                <a:latin typeface="Times New Roman"/>
                <a:cs typeface="Times New Roman"/>
              </a:rPr>
              <a:t>μm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12932"/>
            <a:ext cx="25531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Supplemental 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177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78013" y="1125111"/>
            <a:ext cx="6779987" cy="3810102"/>
            <a:chOff x="78013" y="1125111"/>
            <a:chExt cx="6779987" cy="3810102"/>
          </a:xfrm>
        </p:grpSpPr>
        <p:grpSp>
          <p:nvGrpSpPr>
            <p:cNvPr id="4" name="Group 3"/>
            <p:cNvGrpSpPr/>
            <p:nvPr/>
          </p:nvGrpSpPr>
          <p:grpSpPr>
            <a:xfrm>
              <a:off x="78013" y="1125992"/>
              <a:ext cx="2191714" cy="1838756"/>
              <a:chOff x="723120" y="241414"/>
              <a:chExt cx="2191714" cy="1838756"/>
            </a:xfrm>
          </p:grpSpPr>
          <p:pic>
            <p:nvPicPr>
              <p:cNvPr id="5" name="Picture 4" descr="PBS 1-2 OOO.jpg"/>
              <p:cNvPicPr>
                <a:picLocks noChangeAspect="1"/>
              </p:cNvPicPr>
              <p:nvPr/>
            </p:nvPicPr>
            <p:blipFill>
              <a:blip r:embed="rId2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23120" y="251370"/>
                <a:ext cx="2191714" cy="1828800"/>
              </a:xfrm>
              <a:prstGeom prst="rect">
                <a:avLst/>
              </a:prstGeom>
            </p:spPr>
          </p:pic>
          <p:sp>
            <p:nvSpPr>
              <p:cNvPr id="6" name="Freeform 5"/>
              <p:cNvSpPr/>
              <p:nvPr/>
            </p:nvSpPr>
            <p:spPr>
              <a:xfrm>
                <a:off x="1216752" y="262407"/>
                <a:ext cx="189614" cy="1805358"/>
              </a:xfrm>
              <a:custGeom>
                <a:avLst/>
                <a:gdLst>
                  <a:gd name="connsiteX0" fmla="*/ 189614 w 189614"/>
                  <a:gd name="connsiteY0" fmla="*/ 0 h 1805358"/>
                  <a:gd name="connsiteX1" fmla="*/ 179118 w 189614"/>
                  <a:gd name="connsiteY1" fmla="*/ 52481 h 1805358"/>
                  <a:gd name="connsiteX2" fmla="*/ 168623 w 189614"/>
                  <a:gd name="connsiteY2" fmla="*/ 83970 h 1805358"/>
                  <a:gd name="connsiteX3" fmla="*/ 147633 w 189614"/>
                  <a:gd name="connsiteY3" fmla="*/ 209925 h 1805358"/>
                  <a:gd name="connsiteX4" fmla="*/ 126642 w 189614"/>
                  <a:gd name="connsiteY4" fmla="*/ 409354 h 1805358"/>
                  <a:gd name="connsiteX5" fmla="*/ 84661 w 189614"/>
                  <a:gd name="connsiteY5" fmla="*/ 503821 h 1805358"/>
                  <a:gd name="connsiteX6" fmla="*/ 63670 w 189614"/>
                  <a:gd name="connsiteY6" fmla="*/ 566798 h 1805358"/>
                  <a:gd name="connsiteX7" fmla="*/ 32185 w 189614"/>
                  <a:gd name="connsiteY7" fmla="*/ 629776 h 1805358"/>
                  <a:gd name="connsiteX8" fmla="*/ 11194 w 189614"/>
                  <a:gd name="connsiteY8" fmla="*/ 661265 h 1805358"/>
                  <a:gd name="connsiteX9" fmla="*/ 32185 w 189614"/>
                  <a:gd name="connsiteY9" fmla="*/ 776724 h 1805358"/>
                  <a:gd name="connsiteX10" fmla="*/ 74166 w 189614"/>
                  <a:gd name="connsiteY10" fmla="*/ 839701 h 1805358"/>
                  <a:gd name="connsiteX11" fmla="*/ 95156 w 189614"/>
                  <a:gd name="connsiteY11" fmla="*/ 923671 h 1805358"/>
                  <a:gd name="connsiteX12" fmla="*/ 105651 w 189614"/>
                  <a:gd name="connsiteY12" fmla="*/ 986649 h 1805358"/>
                  <a:gd name="connsiteX13" fmla="*/ 126642 w 189614"/>
                  <a:gd name="connsiteY13" fmla="*/ 1049627 h 1805358"/>
                  <a:gd name="connsiteX14" fmla="*/ 105651 w 189614"/>
                  <a:gd name="connsiteY14" fmla="*/ 1154589 h 1805358"/>
                  <a:gd name="connsiteX15" fmla="*/ 74166 w 189614"/>
                  <a:gd name="connsiteY15" fmla="*/ 1364515 h 1805358"/>
                  <a:gd name="connsiteX16" fmla="*/ 42680 w 189614"/>
                  <a:gd name="connsiteY16" fmla="*/ 1500966 h 1805358"/>
                  <a:gd name="connsiteX17" fmla="*/ 32185 w 189614"/>
                  <a:gd name="connsiteY17" fmla="*/ 1532455 h 1805358"/>
                  <a:gd name="connsiteX18" fmla="*/ 21689 w 189614"/>
                  <a:gd name="connsiteY18" fmla="*/ 1679403 h 1805358"/>
                  <a:gd name="connsiteX19" fmla="*/ 699 w 189614"/>
                  <a:gd name="connsiteY19" fmla="*/ 1805358 h 18053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</a:cxnLst>
                <a:rect l="l" t="t" r="r" b="b"/>
                <a:pathLst>
                  <a:path w="189614" h="1805358">
                    <a:moveTo>
                      <a:pt x="189614" y="0"/>
                    </a:moveTo>
                    <a:cubicBezTo>
                      <a:pt x="186115" y="17494"/>
                      <a:pt x="183445" y="35173"/>
                      <a:pt x="179118" y="52481"/>
                    </a:cubicBezTo>
                    <a:cubicBezTo>
                      <a:pt x="176435" y="63215"/>
                      <a:pt x="170793" y="73121"/>
                      <a:pt x="168623" y="83970"/>
                    </a:cubicBezTo>
                    <a:cubicBezTo>
                      <a:pt x="160276" y="125708"/>
                      <a:pt x="151486" y="167536"/>
                      <a:pt x="147633" y="209925"/>
                    </a:cubicBezTo>
                    <a:cubicBezTo>
                      <a:pt x="145609" y="232194"/>
                      <a:pt x="133882" y="375564"/>
                      <a:pt x="126642" y="409354"/>
                    </a:cubicBezTo>
                    <a:cubicBezTo>
                      <a:pt x="100783" y="530042"/>
                      <a:pt x="118426" y="427843"/>
                      <a:pt x="84661" y="503821"/>
                    </a:cubicBezTo>
                    <a:cubicBezTo>
                      <a:pt x="75675" y="524042"/>
                      <a:pt x="75943" y="548386"/>
                      <a:pt x="63670" y="566798"/>
                    </a:cubicBezTo>
                    <a:cubicBezTo>
                      <a:pt x="3510" y="657049"/>
                      <a:pt x="75641" y="542855"/>
                      <a:pt x="32185" y="629776"/>
                    </a:cubicBezTo>
                    <a:cubicBezTo>
                      <a:pt x="26544" y="641059"/>
                      <a:pt x="18191" y="650769"/>
                      <a:pt x="11194" y="661265"/>
                    </a:cubicBezTo>
                    <a:cubicBezTo>
                      <a:pt x="13482" y="679572"/>
                      <a:pt x="16526" y="748536"/>
                      <a:pt x="32185" y="776724"/>
                    </a:cubicBezTo>
                    <a:cubicBezTo>
                      <a:pt x="44437" y="798778"/>
                      <a:pt x="74166" y="839701"/>
                      <a:pt x="74166" y="839701"/>
                    </a:cubicBezTo>
                    <a:cubicBezTo>
                      <a:pt x="88731" y="883401"/>
                      <a:pt x="85025" y="867941"/>
                      <a:pt x="95156" y="923671"/>
                    </a:cubicBezTo>
                    <a:cubicBezTo>
                      <a:pt x="98963" y="944610"/>
                      <a:pt x="100490" y="966002"/>
                      <a:pt x="105651" y="986649"/>
                    </a:cubicBezTo>
                    <a:cubicBezTo>
                      <a:pt x="111017" y="1008116"/>
                      <a:pt x="126642" y="1049627"/>
                      <a:pt x="126642" y="1049627"/>
                    </a:cubicBezTo>
                    <a:cubicBezTo>
                      <a:pt x="107246" y="1107820"/>
                      <a:pt x="120122" y="1062931"/>
                      <a:pt x="105651" y="1154589"/>
                    </a:cubicBezTo>
                    <a:cubicBezTo>
                      <a:pt x="62496" y="1427928"/>
                      <a:pt x="101556" y="1159076"/>
                      <a:pt x="74166" y="1364515"/>
                    </a:cubicBezTo>
                    <a:cubicBezTo>
                      <a:pt x="62056" y="1455350"/>
                      <a:pt x="70138" y="1418583"/>
                      <a:pt x="42680" y="1500966"/>
                    </a:cubicBezTo>
                    <a:lnTo>
                      <a:pt x="32185" y="1532455"/>
                    </a:lnTo>
                    <a:cubicBezTo>
                      <a:pt x="28686" y="1581438"/>
                      <a:pt x="28973" y="1630839"/>
                      <a:pt x="21689" y="1679403"/>
                    </a:cubicBezTo>
                    <a:cubicBezTo>
                      <a:pt x="-5939" y="1863604"/>
                      <a:pt x="699" y="1624140"/>
                      <a:pt x="699" y="1805358"/>
                    </a:cubicBez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Freeform 6"/>
              <p:cNvSpPr/>
              <p:nvPr/>
            </p:nvSpPr>
            <p:spPr>
              <a:xfrm>
                <a:off x="1973110" y="241414"/>
                <a:ext cx="178924" cy="1826351"/>
              </a:xfrm>
              <a:custGeom>
                <a:avLst/>
                <a:gdLst>
                  <a:gd name="connsiteX0" fmla="*/ 94457 w 178924"/>
                  <a:gd name="connsiteY0" fmla="*/ 0 h 1826351"/>
                  <a:gd name="connsiteX1" fmla="*/ 104953 w 178924"/>
                  <a:gd name="connsiteY1" fmla="*/ 220422 h 1826351"/>
                  <a:gd name="connsiteX2" fmla="*/ 115448 w 178924"/>
                  <a:gd name="connsiteY2" fmla="*/ 251911 h 1826351"/>
                  <a:gd name="connsiteX3" fmla="*/ 136438 w 178924"/>
                  <a:gd name="connsiteY3" fmla="*/ 283399 h 1826351"/>
                  <a:gd name="connsiteX4" fmla="*/ 136438 w 178924"/>
                  <a:gd name="connsiteY4" fmla="*/ 556302 h 1826351"/>
                  <a:gd name="connsiteX5" fmla="*/ 146934 w 178924"/>
                  <a:gd name="connsiteY5" fmla="*/ 860694 h 1826351"/>
                  <a:gd name="connsiteX6" fmla="*/ 167924 w 178924"/>
                  <a:gd name="connsiteY6" fmla="*/ 923672 h 1826351"/>
                  <a:gd name="connsiteX7" fmla="*/ 167924 w 178924"/>
                  <a:gd name="connsiteY7" fmla="*/ 1196575 h 1826351"/>
                  <a:gd name="connsiteX8" fmla="*/ 146934 w 178924"/>
                  <a:gd name="connsiteY8" fmla="*/ 1228064 h 1826351"/>
                  <a:gd name="connsiteX9" fmla="*/ 125943 w 178924"/>
                  <a:gd name="connsiteY9" fmla="*/ 1291041 h 1826351"/>
                  <a:gd name="connsiteX10" fmla="*/ 104953 w 178924"/>
                  <a:gd name="connsiteY10" fmla="*/ 1354019 h 1826351"/>
                  <a:gd name="connsiteX11" fmla="*/ 83962 w 178924"/>
                  <a:gd name="connsiteY11" fmla="*/ 1416997 h 1826351"/>
                  <a:gd name="connsiteX12" fmla="*/ 73467 w 178924"/>
                  <a:gd name="connsiteY12" fmla="*/ 1479974 h 1826351"/>
                  <a:gd name="connsiteX13" fmla="*/ 41981 w 178924"/>
                  <a:gd name="connsiteY13" fmla="*/ 1542952 h 1826351"/>
                  <a:gd name="connsiteX14" fmla="*/ 31486 w 178924"/>
                  <a:gd name="connsiteY14" fmla="*/ 1574441 h 1826351"/>
                  <a:gd name="connsiteX15" fmla="*/ 20990 w 178924"/>
                  <a:gd name="connsiteY15" fmla="*/ 1679403 h 1826351"/>
                  <a:gd name="connsiteX16" fmla="*/ 0 w 178924"/>
                  <a:gd name="connsiteY16" fmla="*/ 1742381 h 1826351"/>
                  <a:gd name="connsiteX17" fmla="*/ 10495 w 178924"/>
                  <a:gd name="connsiteY17" fmla="*/ 1826351 h 182635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178924" h="1826351">
                    <a:moveTo>
                      <a:pt x="94457" y="0"/>
                    </a:moveTo>
                    <a:cubicBezTo>
                      <a:pt x="97956" y="73474"/>
                      <a:pt x="98845" y="147119"/>
                      <a:pt x="104953" y="220422"/>
                    </a:cubicBezTo>
                    <a:cubicBezTo>
                      <a:pt x="105872" y="231448"/>
                      <a:pt x="110500" y="242015"/>
                      <a:pt x="115448" y="251911"/>
                    </a:cubicBezTo>
                    <a:cubicBezTo>
                      <a:pt x="121089" y="263194"/>
                      <a:pt x="129441" y="272903"/>
                      <a:pt x="136438" y="283399"/>
                    </a:cubicBezTo>
                    <a:cubicBezTo>
                      <a:pt x="119152" y="508140"/>
                      <a:pt x="125737" y="331562"/>
                      <a:pt x="136438" y="556302"/>
                    </a:cubicBezTo>
                    <a:cubicBezTo>
                      <a:pt x="141267" y="657711"/>
                      <a:pt x="138264" y="759541"/>
                      <a:pt x="146934" y="860694"/>
                    </a:cubicBezTo>
                    <a:cubicBezTo>
                      <a:pt x="148824" y="882741"/>
                      <a:pt x="167924" y="923672"/>
                      <a:pt x="167924" y="923672"/>
                    </a:cubicBezTo>
                    <a:cubicBezTo>
                      <a:pt x="170925" y="980689"/>
                      <a:pt x="191101" y="1119310"/>
                      <a:pt x="167924" y="1196575"/>
                    </a:cubicBezTo>
                    <a:cubicBezTo>
                      <a:pt x="164300" y="1208658"/>
                      <a:pt x="152057" y="1216537"/>
                      <a:pt x="146934" y="1228064"/>
                    </a:cubicBezTo>
                    <a:cubicBezTo>
                      <a:pt x="137948" y="1248285"/>
                      <a:pt x="132940" y="1270049"/>
                      <a:pt x="125943" y="1291041"/>
                    </a:cubicBezTo>
                    <a:lnTo>
                      <a:pt x="104953" y="1354019"/>
                    </a:lnTo>
                    <a:cubicBezTo>
                      <a:pt x="104951" y="1354026"/>
                      <a:pt x="83963" y="1416989"/>
                      <a:pt x="83962" y="1416997"/>
                    </a:cubicBezTo>
                    <a:cubicBezTo>
                      <a:pt x="80464" y="1437989"/>
                      <a:pt x="78083" y="1459199"/>
                      <a:pt x="73467" y="1479974"/>
                    </a:cubicBezTo>
                    <a:cubicBezTo>
                      <a:pt x="62915" y="1527461"/>
                      <a:pt x="64624" y="1497661"/>
                      <a:pt x="41981" y="1542952"/>
                    </a:cubicBezTo>
                    <a:cubicBezTo>
                      <a:pt x="37034" y="1552848"/>
                      <a:pt x="34984" y="1563945"/>
                      <a:pt x="31486" y="1574441"/>
                    </a:cubicBezTo>
                    <a:cubicBezTo>
                      <a:pt x="27987" y="1609428"/>
                      <a:pt x="27469" y="1644843"/>
                      <a:pt x="20990" y="1679403"/>
                    </a:cubicBezTo>
                    <a:cubicBezTo>
                      <a:pt x="16912" y="1701152"/>
                      <a:pt x="0" y="1742381"/>
                      <a:pt x="0" y="1742381"/>
                    </a:cubicBezTo>
                    <a:cubicBezTo>
                      <a:pt x="12553" y="1805155"/>
                      <a:pt x="10495" y="1777022"/>
                      <a:pt x="10495" y="1826351"/>
                    </a:cubicBez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338404" y="1125992"/>
              <a:ext cx="2191714" cy="1836847"/>
              <a:chOff x="723120" y="2193720"/>
              <a:chExt cx="2191714" cy="1836847"/>
            </a:xfrm>
          </p:grpSpPr>
          <p:pic>
            <p:nvPicPr>
              <p:cNvPr id="9" name="Picture 8" descr="PBS 1-3 OOO.jpg"/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23120" y="2199222"/>
                <a:ext cx="2191714" cy="1828800"/>
              </a:xfrm>
              <a:prstGeom prst="rect">
                <a:avLst/>
              </a:prstGeom>
            </p:spPr>
          </p:pic>
          <p:sp>
            <p:nvSpPr>
              <p:cNvPr id="10" name="Freeform 9"/>
              <p:cNvSpPr/>
              <p:nvPr/>
            </p:nvSpPr>
            <p:spPr>
              <a:xfrm>
                <a:off x="1122993" y="2204217"/>
                <a:ext cx="83963" cy="1815854"/>
              </a:xfrm>
              <a:custGeom>
                <a:avLst/>
                <a:gdLst>
                  <a:gd name="connsiteX0" fmla="*/ 62972 w 83963"/>
                  <a:gd name="connsiteY0" fmla="*/ 0 h 1815854"/>
                  <a:gd name="connsiteX1" fmla="*/ 73467 w 83963"/>
                  <a:gd name="connsiteY1" fmla="*/ 356873 h 1815854"/>
                  <a:gd name="connsiteX2" fmla="*/ 83963 w 83963"/>
                  <a:gd name="connsiteY2" fmla="*/ 409354 h 1815854"/>
                  <a:gd name="connsiteX3" fmla="*/ 62972 w 83963"/>
                  <a:gd name="connsiteY3" fmla="*/ 608783 h 1815854"/>
                  <a:gd name="connsiteX4" fmla="*/ 52477 w 83963"/>
                  <a:gd name="connsiteY4" fmla="*/ 776724 h 1815854"/>
                  <a:gd name="connsiteX5" fmla="*/ 31486 w 83963"/>
                  <a:gd name="connsiteY5" fmla="*/ 913175 h 1815854"/>
                  <a:gd name="connsiteX6" fmla="*/ 41981 w 83963"/>
                  <a:gd name="connsiteY6" fmla="*/ 1018138 h 1815854"/>
                  <a:gd name="connsiteX7" fmla="*/ 41981 w 83963"/>
                  <a:gd name="connsiteY7" fmla="*/ 1144093 h 1815854"/>
                  <a:gd name="connsiteX8" fmla="*/ 10496 w 83963"/>
                  <a:gd name="connsiteY8" fmla="*/ 1165085 h 1815854"/>
                  <a:gd name="connsiteX9" fmla="*/ 0 w 83963"/>
                  <a:gd name="connsiteY9" fmla="*/ 1196574 h 1815854"/>
                  <a:gd name="connsiteX10" fmla="*/ 20991 w 83963"/>
                  <a:gd name="connsiteY10" fmla="*/ 1333026 h 1815854"/>
                  <a:gd name="connsiteX11" fmla="*/ 41981 w 83963"/>
                  <a:gd name="connsiteY11" fmla="*/ 1396003 h 1815854"/>
                  <a:gd name="connsiteX12" fmla="*/ 41981 w 83963"/>
                  <a:gd name="connsiteY12" fmla="*/ 1574440 h 1815854"/>
                  <a:gd name="connsiteX13" fmla="*/ 62972 w 83963"/>
                  <a:gd name="connsiteY13" fmla="*/ 1679403 h 1815854"/>
                  <a:gd name="connsiteX14" fmla="*/ 52477 w 83963"/>
                  <a:gd name="connsiteY14" fmla="*/ 1815854 h 18158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83963" h="1815854">
                    <a:moveTo>
                      <a:pt x="62972" y="0"/>
                    </a:moveTo>
                    <a:cubicBezTo>
                      <a:pt x="66470" y="118958"/>
                      <a:pt x="67372" y="238020"/>
                      <a:pt x="73467" y="356873"/>
                    </a:cubicBezTo>
                    <a:cubicBezTo>
                      <a:pt x="74381" y="374690"/>
                      <a:pt x="83963" y="391514"/>
                      <a:pt x="83963" y="409354"/>
                    </a:cubicBezTo>
                    <a:cubicBezTo>
                      <a:pt x="83963" y="535364"/>
                      <a:pt x="83081" y="528339"/>
                      <a:pt x="62972" y="608783"/>
                    </a:cubicBezTo>
                    <a:cubicBezTo>
                      <a:pt x="59474" y="664763"/>
                      <a:pt x="57135" y="720828"/>
                      <a:pt x="52477" y="776724"/>
                    </a:cubicBezTo>
                    <a:cubicBezTo>
                      <a:pt x="47031" y="842077"/>
                      <a:pt x="42919" y="856004"/>
                      <a:pt x="31486" y="913175"/>
                    </a:cubicBezTo>
                    <a:cubicBezTo>
                      <a:pt x="34984" y="948163"/>
                      <a:pt x="36635" y="983385"/>
                      <a:pt x="41981" y="1018138"/>
                    </a:cubicBezTo>
                    <a:cubicBezTo>
                      <a:pt x="51968" y="1083061"/>
                      <a:pt x="83844" y="1028960"/>
                      <a:pt x="41981" y="1144093"/>
                    </a:cubicBezTo>
                    <a:cubicBezTo>
                      <a:pt x="37671" y="1155947"/>
                      <a:pt x="20991" y="1158088"/>
                      <a:pt x="10496" y="1165085"/>
                    </a:cubicBezTo>
                    <a:cubicBezTo>
                      <a:pt x="6997" y="1175581"/>
                      <a:pt x="0" y="1185510"/>
                      <a:pt x="0" y="1196574"/>
                    </a:cubicBezTo>
                    <a:cubicBezTo>
                      <a:pt x="0" y="1238457"/>
                      <a:pt x="8317" y="1290774"/>
                      <a:pt x="20991" y="1333026"/>
                    </a:cubicBezTo>
                    <a:cubicBezTo>
                      <a:pt x="27349" y="1354221"/>
                      <a:pt x="41981" y="1396003"/>
                      <a:pt x="41981" y="1396003"/>
                    </a:cubicBezTo>
                    <a:cubicBezTo>
                      <a:pt x="28738" y="1488719"/>
                      <a:pt x="25864" y="1466985"/>
                      <a:pt x="41981" y="1574440"/>
                    </a:cubicBezTo>
                    <a:cubicBezTo>
                      <a:pt x="47273" y="1609726"/>
                      <a:pt x="62972" y="1679403"/>
                      <a:pt x="62972" y="1679403"/>
                    </a:cubicBezTo>
                    <a:lnTo>
                      <a:pt x="52477" y="1815854"/>
                    </a:ln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Freeform 10"/>
              <p:cNvSpPr/>
              <p:nvPr/>
            </p:nvSpPr>
            <p:spPr>
              <a:xfrm>
                <a:off x="1910138" y="2193720"/>
                <a:ext cx="125952" cy="1836847"/>
              </a:xfrm>
              <a:custGeom>
                <a:avLst/>
                <a:gdLst>
                  <a:gd name="connsiteX0" fmla="*/ 62972 w 125952"/>
                  <a:gd name="connsiteY0" fmla="*/ 0 h 1836847"/>
                  <a:gd name="connsiteX1" fmla="*/ 41981 w 125952"/>
                  <a:gd name="connsiteY1" fmla="*/ 178437 h 1836847"/>
                  <a:gd name="connsiteX2" fmla="*/ 31486 w 125952"/>
                  <a:gd name="connsiteY2" fmla="*/ 251911 h 1836847"/>
                  <a:gd name="connsiteX3" fmla="*/ 20991 w 125952"/>
                  <a:gd name="connsiteY3" fmla="*/ 346377 h 1836847"/>
                  <a:gd name="connsiteX4" fmla="*/ 10496 w 125952"/>
                  <a:gd name="connsiteY4" fmla="*/ 409355 h 1836847"/>
                  <a:gd name="connsiteX5" fmla="*/ 0 w 125952"/>
                  <a:gd name="connsiteY5" fmla="*/ 503821 h 1836847"/>
                  <a:gd name="connsiteX6" fmla="*/ 10496 w 125952"/>
                  <a:gd name="connsiteY6" fmla="*/ 724243 h 1836847"/>
                  <a:gd name="connsiteX7" fmla="*/ 20991 w 125952"/>
                  <a:gd name="connsiteY7" fmla="*/ 881687 h 1836847"/>
                  <a:gd name="connsiteX8" fmla="*/ 10496 w 125952"/>
                  <a:gd name="connsiteY8" fmla="*/ 997146 h 1836847"/>
                  <a:gd name="connsiteX9" fmla="*/ 31486 w 125952"/>
                  <a:gd name="connsiteY9" fmla="*/ 1259553 h 1836847"/>
                  <a:gd name="connsiteX10" fmla="*/ 41981 w 125952"/>
                  <a:gd name="connsiteY10" fmla="*/ 1542952 h 1836847"/>
                  <a:gd name="connsiteX11" fmla="*/ 62972 w 125952"/>
                  <a:gd name="connsiteY11" fmla="*/ 1668907 h 1836847"/>
                  <a:gd name="connsiteX12" fmla="*/ 83962 w 125952"/>
                  <a:gd name="connsiteY12" fmla="*/ 1731885 h 1836847"/>
                  <a:gd name="connsiteX13" fmla="*/ 104953 w 125952"/>
                  <a:gd name="connsiteY13" fmla="*/ 1763374 h 1836847"/>
                  <a:gd name="connsiteX14" fmla="*/ 125943 w 125952"/>
                  <a:gd name="connsiteY14" fmla="*/ 1836847 h 18368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125952" h="1836847">
                    <a:moveTo>
                      <a:pt x="62972" y="0"/>
                    </a:moveTo>
                    <a:cubicBezTo>
                      <a:pt x="41398" y="107883"/>
                      <a:pt x="60612" y="1433"/>
                      <a:pt x="41981" y="178437"/>
                    </a:cubicBezTo>
                    <a:cubicBezTo>
                      <a:pt x="39391" y="203041"/>
                      <a:pt x="34554" y="227362"/>
                      <a:pt x="31486" y="251911"/>
                    </a:cubicBezTo>
                    <a:cubicBezTo>
                      <a:pt x="27557" y="283349"/>
                      <a:pt x="25178" y="314972"/>
                      <a:pt x="20991" y="346377"/>
                    </a:cubicBezTo>
                    <a:cubicBezTo>
                      <a:pt x="18179" y="367473"/>
                      <a:pt x="13309" y="388260"/>
                      <a:pt x="10496" y="409355"/>
                    </a:cubicBezTo>
                    <a:cubicBezTo>
                      <a:pt x="6309" y="440760"/>
                      <a:pt x="3499" y="472332"/>
                      <a:pt x="0" y="503821"/>
                    </a:cubicBezTo>
                    <a:cubicBezTo>
                      <a:pt x="3499" y="577295"/>
                      <a:pt x="6416" y="650799"/>
                      <a:pt x="10496" y="724243"/>
                    </a:cubicBezTo>
                    <a:cubicBezTo>
                      <a:pt x="13413" y="776760"/>
                      <a:pt x="20991" y="829089"/>
                      <a:pt x="20991" y="881687"/>
                    </a:cubicBezTo>
                    <a:cubicBezTo>
                      <a:pt x="20991" y="920332"/>
                      <a:pt x="13994" y="958660"/>
                      <a:pt x="10496" y="997146"/>
                    </a:cubicBezTo>
                    <a:cubicBezTo>
                      <a:pt x="18303" y="1083036"/>
                      <a:pt x="27302" y="1173779"/>
                      <a:pt x="31486" y="1259553"/>
                    </a:cubicBezTo>
                    <a:cubicBezTo>
                      <a:pt x="36091" y="1353972"/>
                      <a:pt x="36588" y="1448575"/>
                      <a:pt x="41981" y="1542952"/>
                    </a:cubicBezTo>
                    <a:cubicBezTo>
                      <a:pt x="44432" y="1585851"/>
                      <a:pt x="50666" y="1627880"/>
                      <a:pt x="62972" y="1668907"/>
                    </a:cubicBezTo>
                    <a:cubicBezTo>
                      <a:pt x="69330" y="1690102"/>
                      <a:pt x="71688" y="1713473"/>
                      <a:pt x="83962" y="1731885"/>
                    </a:cubicBezTo>
                    <a:lnTo>
                      <a:pt x="104953" y="1763374"/>
                    </a:lnTo>
                    <a:cubicBezTo>
                      <a:pt x="127049" y="1829670"/>
                      <a:pt x="125943" y="1804223"/>
                      <a:pt x="125943" y="1836847"/>
                    </a:cubicBez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4595909" y="1125992"/>
              <a:ext cx="2196612" cy="1838250"/>
              <a:chOff x="5290033" y="241920"/>
              <a:chExt cx="2196612" cy="1838250"/>
            </a:xfrm>
          </p:grpSpPr>
          <p:pic>
            <p:nvPicPr>
              <p:cNvPr id="17" name="Picture 16" descr="PBS+ TGFB 2-3 O.jpg"/>
              <p:cNvPicPr>
                <a:picLocks noChangeAspect="1"/>
              </p:cNvPicPr>
              <p:nvPr/>
            </p:nvPicPr>
            <p:blipFill rotWithShape="1">
              <a:blip r:embed="rId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223" r="-1"/>
              <a:stretch/>
            </p:blipFill>
            <p:spPr>
              <a:xfrm>
                <a:off x="5290033" y="251370"/>
                <a:ext cx="2196612" cy="1828800"/>
              </a:xfrm>
              <a:prstGeom prst="rect">
                <a:avLst/>
              </a:prstGeom>
            </p:spPr>
          </p:pic>
          <p:sp>
            <p:nvSpPr>
              <p:cNvPr id="18" name="Freeform 17"/>
              <p:cNvSpPr/>
              <p:nvPr/>
            </p:nvSpPr>
            <p:spPr>
              <a:xfrm>
                <a:off x="5659192" y="241920"/>
                <a:ext cx="198712" cy="1831702"/>
              </a:xfrm>
              <a:custGeom>
                <a:avLst/>
                <a:gdLst>
                  <a:gd name="connsiteX0" fmla="*/ 0 w 198712"/>
                  <a:gd name="connsiteY0" fmla="*/ 0 h 1831702"/>
                  <a:gd name="connsiteX1" fmla="*/ 43198 w 198712"/>
                  <a:gd name="connsiteY1" fmla="*/ 95040 h 1831702"/>
                  <a:gd name="connsiteX2" fmla="*/ 86397 w 198712"/>
                  <a:gd name="connsiteY2" fmla="*/ 138240 h 1831702"/>
                  <a:gd name="connsiteX3" fmla="*/ 86397 w 198712"/>
                  <a:gd name="connsiteY3" fmla="*/ 233280 h 1831702"/>
                  <a:gd name="connsiteX4" fmla="*/ 95036 w 198712"/>
                  <a:gd name="connsiteY4" fmla="*/ 397440 h 1831702"/>
                  <a:gd name="connsiteX5" fmla="*/ 120955 w 198712"/>
                  <a:gd name="connsiteY5" fmla="*/ 561600 h 1831702"/>
                  <a:gd name="connsiteX6" fmla="*/ 138234 w 198712"/>
                  <a:gd name="connsiteY6" fmla="*/ 587520 h 1831702"/>
                  <a:gd name="connsiteX7" fmla="*/ 146874 w 198712"/>
                  <a:gd name="connsiteY7" fmla="*/ 622080 h 1831702"/>
                  <a:gd name="connsiteX8" fmla="*/ 164153 w 198712"/>
                  <a:gd name="connsiteY8" fmla="*/ 751680 h 1831702"/>
                  <a:gd name="connsiteX9" fmla="*/ 172793 w 198712"/>
                  <a:gd name="connsiteY9" fmla="*/ 777600 h 1831702"/>
                  <a:gd name="connsiteX10" fmla="*/ 181433 w 198712"/>
                  <a:gd name="connsiteY10" fmla="*/ 812160 h 1831702"/>
                  <a:gd name="connsiteX11" fmla="*/ 198712 w 198712"/>
                  <a:gd name="connsiteY11" fmla="*/ 864000 h 1831702"/>
                  <a:gd name="connsiteX12" fmla="*/ 181433 w 198712"/>
                  <a:gd name="connsiteY12" fmla="*/ 1071360 h 1831702"/>
                  <a:gd name="connsiteX13" fmla="*/ 164153 w 198712"/>
                  <a:gd name="connsiteY13" fmla="*/ 1140480 h 1831702"/>
                  <a:gd name="connsiteX14" fmla="*/ 155514 w 198712"/>
                  <a:gd name="connsiteY14" fmla="*/ 1175040 h 1831702"/>
                  <a:gd name="connsiteX15" fmla="*/ 138234 w 198712"/>
                  <a:gd name="connsiteY15" fmla="*/ 1226880 h 1831702"/>
                  <a:gd name="connsiteX16" fmla="*/ 120955 w 198712"/>
                  <a:gd name="connsiteY16" fmla="*/ 1278720 h 1831702"/>
                  <a:gd name="connsiteX17" fmla="*/ 112316 w 198712"/>
                  <a:gd name="connsiteY17" fmla="*/ 1304640 h 1831702"/>
                  <a:gd name="connsiteX18" fmla="*/ 103676 w 198712"/>
                  <a:gd name="connsiteY18" fmla="*/ 1330560 h 1831702"/>
                  <a:gd name="connsiteX19" fmla="*/ 112316 w 198712"/>
                  <a:gd name="connsiteY19" fmla="*/ 1615680 h 1831702"/>
                  <a:gd name="connsiteX20" fmla="*/ 129595 w 198712"/>
                  <a:gd name="connsiteY20" fmla="*/ 1667520 h 1831702"/>
                  <a:gd name="connsiteX21" fmla="*/ 138234 w 198712"/>
                  <a:gd name="connsiteY21" fmla="*/ 1693440 h 1831702"/>
                  <a:gd name="connsiteX22" fmla="*/ 146874 w 198712"/>
                  <a:gd name="connsiteY22" fmla="*/ 1719360 h 1831702"/>
                  <a:gd name="connsiteX23" fmla="*/ 155514 w 198712"/>
                  <a:gd name="connsiteY23" fmla="*/ 1745280 h 1831702"/>
                  <a:gd name="connsiteX24" fmla="*/ 164153 w 198712"/>
                  <a:gd name="connsiteY24" fmla="*/ 1779840 h 1831702"/>
                  <a:gd name="connsiteX25" fmla="*/ 190072 w 198712"/>
                  <a:gd name="connsiteY25" fmla="*/ 1831680 h 183170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198712" h="1831702">
                    <a:moveTo>
                      <a:pt x="0" y="0"/>
                    </a:moveTo>
                    <a:cubicBezTo>
                      <a:pt x="8938" y="44689"/>
                      <a:pt x="5833" y="57674"/>
                      <a:pt x="43198" y="95040"/>
                    </a:cubicBezTo>
                    <a:lnTo>
                      <a:pt x="86397" y="138240"/>
                    </a:lnTo>
                    <a:cubicBezTo>
                      <a:pt x="106209" y="197684"/>
                      <a:pt x="86397" y="125814"/>
                      <a:pt x="86397" y="233280"/>
                    </a:cubicBezTo>
                    <a:cubicBezTo>
                      <a:pt x="86397" y="288076"/>
                      <a:pt x="91618" y="342751"/>
                      <a:pt x="95036" y="397440"/>
                    </a:cubicBezTo>
                    <a:cubicBezTo>
                      <a:pt x="96779" y="425322"/>
                      <a:pt x="95825" y="523903"/>
                      <a:pt x="120955" y="561600"/>
                    </a:cubicBezTo>
                    <a:lnTo>
                      <a:pt x="138234" y="587520"/>
                    </a:lnTo>
                    <a:cubicBezTo>
                      <a:pt x="141114" y="599040"/>
                      <a:pt x="144922" y="610367"/>
                      <a:pt x="146874" y="622080"/>
                    </a:cubicBezTo>
                    <a:cubicBezTo>
                      <a:pt x="153176" y="659893"/>
                      <a:pt x="156497" y="713395"/>
                      <a:pt x="164153" y="751680"/>
                    </a:cubicBezTo>
                    <a:cubicBezTo>
                      <a:pt x="165939" y="760611"/>
                      <a:pt x="170291" y="768843"/>
                      <a:pt x="172793" y="777600"/>
                    </a:cubicBezTo>
                    <a:cubicBezTo>
                      <a:pt x="176055" y="789018"/>
                      <a:pt x="178021" y="800786"/>
                      <a:pt x="181433" y="812160"/>
                    </a:cubicBezTo>
                    <a:cubicBezTo>
                      <a:pt x="186667" y="829606"/>
                      <a:pt x="198712" y="864000"/>
                      <a:pt x="198712" y="864000"/>
                    </a:cubicBezTo>
                    <a:cubicBezTo>
                      <a:pt x="193909" y="936046"/>
                      <a:pt x="191497" y="1000911"/>
                      <a:pt x="181433" y="1071360"/>
                    </a:cubicBezTo>
                    <a:cubicBezTo>
                      <a:pt x="173905" y="1124062"/>
                      <a:pt x="175640" y="1100274"/>
                      <a:pt x="164153" y="1140480"/>
                    </a:cubicBezTo>
                    <a:cubicBezTo>
                      <a:pt x="160891" y="1151898"/>
                      <a:pt x="158926" y="1163666"/>
                      <a:pt x="155514" y="1175040"/>
                    </a:cubicBezTo>
                    <a:cubicBezTo>
                      <a:pt x="150280" y="1192487"/>
                      <a:pt x="143994" y="1209600"/>
                      <a:pt x="138234" y="1226880"/>
                    </a:cubicBezTo>
                    <a:lnTo>
                      <a:pt x="120955" y="1278720"/>
                    </a:lnTo>
                    <a:lnTo>
                      <a:pt x="112316" y="1304640"/>
                    </a:lnTo>
                    <a:lnTo>
                      <a:pt x="103676" y="1330560"/>
                    </a:lnTo>
                    <a:cubicBezTo>
                      <a:pt x="106556" y="1425600"/>
                      <a:pt x="105024" y="1520876"/>
                      <a:pt x="112316" y="1615680"/>
                    </a:cubicBezTo>
                    <a:cubicBezTo>
                      <a:pt x="113713" y="1633841"/>
                      <a:pt x="123835" y="1650240"/>
                      <a:pt x="129595" y="1667520"/>
                    </a:cubicBezTo>
                    <a:lnTo>
                      <a:pt x="138234" y="1693440"/>
                    </a:lnTo>
                    <a:lnTo>
                      <a:pt x="146874" y="1719360"/>
                    </a:lnTo>
                    <a:cubicBezTo>
                      <a:pt x="149754" y="1728000"/>
                      <a:pt x="153305" y="1736445"/>
                      <a:pt x="155514" y="1745280"/>
                    </a:cubicBezTo>
                    <a:cubicBezTo>
                      <a:pt x="158394" y="1756800"/>
                      <a:pt x="160741" y="1768466"/>
                      <a:pt x="164153" y="1779840"/>
                    </a:cubicBezTo>
                    <a:cubicBezTo>
                      <a:pt x="180524" y="1834412"/>
                      <a:pt x="163506" y="1831680"/>
                      <a:pt x="190072" y="1831680"/>
                    </a:cubicBez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Freeform 18"/>
              <p:cNvSpPr/>
              <p:nvPr/>
            </p:nvSpPr>
            <p:spPr>
              <a:xfrm>
                <a:off x="6583636" y="247745"/>
                <a:ext cx="215991" cy="1831680"/>
              </a:xfrm>
              <a:custGeom>
                <a:avLst/>
                <a:gdLst>
                  <a:gd name="connsiteX0" fmla="*/ 0 w 215991"/>
                  <a:gd name="connsiteY0" fmla="*/ 0 h 1831680"/>
                  <a:gd name="connsiteX1" fmla="*/ 34558 w 215991"/>
                  <a:gd name="connsiteY1" fmla="*/ 43200 h 1831680"/>
                  <a:gd name="connsiteX2" fmla="*/ 51837 w 215991"/>
                  <a:gd name="connsiteY2" fmla="*/ 69120 h 1831680"/>
                  <a:gd name="connsiteX3" fmla="*/ 43198 w 215991"/>
                  <a:gd name="connsiteY3" fmla="*/ 112320 h 1831680"/>
                  <a:gd name="connsiteX4" fmla="*/ 34558 w 215991"/>
                  <a:gd name="connsiteY4" fmla="*/ 267840 h 1831680"/>
                  <a:gd name="connsiteX5" fmla="*/ 17279 w 215991"/>
                  <a:gd name="connsiteY5" fmla="*/ 319680 h 1831680"/>
                  <a:gd name="connsiteX6" fmla="*/ 8639 w 215991"/>
                  <a:gd name="connsiteY6" fmla="*/ 345600 h 1831680"/>
                  <a:gd name="connsiteX7" fmla="*/ 25919 w 215991"/>
                  <a:gd name="connsiteY7" fmla="*/ 535680 h 1831680"/>
                  <a:gd name="connsiteX8" fmla="*/ 34558 w 215991"/>
                  <a:gd name="connsiteY8" fmla="*/ 561600 h 1831680"/>
                  <a:gd name="connsiteX9" fmla="*/ 51837 w 215991"/>
                  <a:gd name="connsiteY9" fmla="*/ 587520 h 1831680"/>
                  <a:gd name="connsiteX10" fmla="*/ 77756 w 215991"/>
                  <a:gd name="connsiteY10" fmla="*/ 596160 h 1831680"/>
                  <a:gd name="connsiteX11" fmla="*/ 77756 w 215991"/>
                  <a:gd name="connsiteY11" fmla="*/ 665280 h 1831680"/>
                  <a:gd name="connsiteX12" fmla="*/ 86396 w 215991"/>
                  <a:gd name="connsiteY12" fmla="*/ 803520 h 1831680"/>
                  <a:gd name="connsiteX13" fmla="*/ 112315 w 215991"/>
                  <a:gd name="connsiteY13" fmla="*/ 855360 h 1831680"/>
                  <a:gd name="connsiteX14" fmla="*/ 129594 w 215991"/>
                  <a:gd name="connsiteY14" fmla="*/ 907200 h 1831680"/>
                  <a:gd name="connsiteX15" fmla="*/ 138234 w 215991"/>
                  <a:gd name="connsiteY15" fmla="*/ 933120 h 1831680"/>
                  <a:gd name="connsiteX16" fmla="*/ 155513 w 215991"/>
                  <a:gd name="connsiteY16" fmla="*/ 1019520 h 1831680"/>
                  <a:gd name="connsiteX17" fmla="*/ 172793 w 215991"/>
                  <a:gd name="connsiteY17" fmla="*/ 1105920 h 1831680"/>
                  <a:gd name="connsiteX18" fmla="*/ 190072 w 215991"/>
                  <a:gd name="connsiteY18" fmla="*/ 1157760 h 1831680"/>
                  <a:gd name="connsiteX19" fmla="*/ 207351 w 215991"/>
                  <a:gd name="connsiteY19" fmla="*/ 1235520 h 1831680"/>
                  <a:gd name="connsiteX20" fmla="*/ 215991 w 215991"/>
                  <a:gd name="connsiteY20" fmla="*/ 1313280 h 1831680"/>
                  <a:gd name="connsiteX21" fmla="*/ 207351 w 215991"/>
                  <a:gd name="connsiteY21" fmla="*/ 1416960 h 1831680"/>
                  <a:gd name="connsiteX22" fmla="*/ 198712 w 215991"/>
                  <a:gd name="connsiteY22" fmla="*/ 1442880 h 1831680"/>
                  <a:gd name="connsiteX23" fmla="*/ 181432 w 215991"/>
                  <a:gd name="connsiteY23" fmla="*/ 1529280 h 1831680"/>
                  <a:gd name="connsiteX24" fmla="*/ 164153 w 215991"/>
                  <a:gd name="connsiteY24" fmla="*/ 1641600 h 1831680"/>
                  <a:gd name="connsiteX25" fmla="*/ 155513 w 215991"/>
                  <a:gd name="connsiteY25" fmla="*/ 1684800 h 1831680"/>
                  <a:gd name="connsiteX26" fmla="*/ 138234 w 215991"/>
                  <a:gd name="connsiteY26" fmla="*/ 1719360 h 1831680"/>
                  <a:gd name="connsiteX27" fmla="*/ 129594 w 215991"/>
                  <a:gd name="connsiteY27" fmla="*/ 1745280 h 1831680"/>
                  <a:gd name="connsiteX28" fmla="*/ 120955 w 215991"/>
                  <a:gd name="connsiteY28" fmla="*/ 1831680 h 18316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215991" h="1831680">
                    <a:moveTo>
                      <a:pt x="0" y="0"/>
                    </a:moveTo>
                    <a:cubicBezTo>
                      <a:pt x="11519" y="14400"/>
                      <a:pt x="23494" y="28447"/>
                      <a:pt x="34558" y="43200"/>
                    </a:cubicBezTo>
                    <a:cubicBezTo>
                      <a:pt x="40788" y="51507"/>
                      <a:pt x="50549" y="58816"/>
                      <a:pt x="51837" y="69120"/>
                    </a:cubicBezTo>
                    <a:cubicBezTo>
                      <a:pt x="53658" y="83692"/>
                      <a:pt x="46078" y="97920"/>
                      <a:pt x="43198" y="112320"/>
                    </a:cubicBezTo>
                    <a:cubicBezTo>
                      <a:pt x="40318" y="164160"/>
                      <a:pt x="40998" y="216321"/>
                      <a:pt x="34558" y="267840"/>
                    </a:cubicBezTo>
                    <a:cubicBezTo>
                      <a:pt x="32299" y="285914"/>
                      <a:pt x="23039" y="302400"/>
                      <a:pt x="17279" y="319680"/>
                    </a:cubicBezTo>
                    <a:lnTo>
                      <a:pt x="8639" y="345600"/>
                    </a:lnTo>
                    <a:cubicBezTo>
                      <a:pt x="14738" y="455376"/>
                      <a:pt x="5418" y="463924"/>
                      <a:pt x="25919" y="535680"/>
                    </a:cubicBezTo>
                    <a:cubicBezTo>
                      <a:pt x="28421" y="544437"/>
                      <a:pt x="30485" y="553454"/>
                      <a:pt x="34558" y="561600"/>
                    </a:cubicBezTo>
                    <a:cubicBezTo>
                      <a:pt x="39201" y="570888"/>
                      <a:pt x="43729" y="581033"/>
                      <a:pt x="51837" y="587520"/>
                    </a:cubicBezTo>
                    <a:cubicBezTo>
                      <a:pt x="58948" y="593209"/>
                      <a:pt x="69116" y="593280"/>
                      <a:pt x="77756" y="596160"/>
                    </a:cubicBezTo>
                    <a:cubicBezTo>
                      <a:pt x="97506" y="655410"/>
                      <a:pt x="77756" y="581871"/>
                      <a:pt x="77756" y="665280"/>
                    </a:cubicBezTo>
                    <a:cubicBezTo>
                      <a:pt x="77756" y="711450"/>
                      <a:pt x="81563" y="757604"/>
                      <a:pt x="86396" y="803520"/>
                    </a:cubicBezTo>
                    <a:cubicBezTo>
                      <a:pt x="89656" y="834486"/>
                      <a:pt x="99863" y="827341"/>
                      <a:pt x="112315" y="855360"/>
                    </a:cubicBezTo>
                    <a:cubicBezTo>
                      <a:pt x="119712" y="872005"/>
                      <a:pt x="123834" y="889920"/>
                      <a:pt x="129594" y="907200"/>
                    </a:cubicBezTo>
                    <a:cubicBezTo>
                      <a:pt x="132474" y="915840"/>
                      <a:pt x="136737" y="924137"/>
                      <a:pt x="138234" y="933120"/>
                    </a:cubicBezTo>
                    <a:cubicBezTo>
                      <a:pt x="158330" y="1053694"/>
                      <a:pt x="136184" y="929314"/>
                      <a:pt x="155513" y="1019520"/>
                    </a:cubicBezTo>
                    <a:cubicBezTo>
                      <a:pt x="161667" y="1048238"/>
                      <a:pt x="163506" y="1078057"/>
                      <a:pt x="172793" y="1105920"/>
                    </a:cubicBezTo>
                    <a:cubicBezTo>
                      <a:pt x="178553" y="1123200"/>
                      <a:pt x="185654" y="1140089"/>
                      <a:pt x="190072" y="1157760"/>
                    </a:cubicBezTo>
                    <a:cubicBezTo>
                      <a:pt x="196363" y="1182923"/>
                      <a:pt x="203694" y="1209916"/>
                      <a:pt x="207351" y="1235520"/>
                    </a:cubicBezTo>
                    <a:cubicBezTo>
                      <a:pt x="211039" y="1261337"/>
                      <a:pt x="213111" y="1287360"/>
                      <a:pt x="215991" y="1313280"/>
                    </a:cubicBezTo>
                    <a:cubicBezTo>
                      <a:pt x="213111" y="1347840"/>
                      <a:pt x="211934" y="1382584"/>
                      <a:pt x="207351" y="1416960"/>
                    </a:cubicBezTo>
                    <a:cubicBezTo>
                      <a:pt x="206147" y="1425987"/>
                      <a:pt x="201214" y="1434123"/>
                      <a:pt x="198712" y="1442880"/>
                    </a:cubicBezTo>
                    <a:cubicBezTo>
                      <a:pt x="189168" y="1476287"/>
                      <a:pt x="187090" y="1492501"/>
                      <a:pt x="181432" y="1529280"/>
                    </a:cubicBezTo>
                    <a:cubicBezTo>
                      <a:pt x="171720" y="1592410"/>
                      <a:pt x="174933" y="1582311"/>
                      <a:pt x="164153" y="1641600"/>
                    </a:cubicBezTo>
                    <a:cubicBezTo>
                      <a:pt x="161526" y="1656048"/>
                      <a:pt x="160157" y="1670868"/>
                      <a:pt x="155513" y="1684800"/>
                    </a:cubicBezTo>
                    <a:cubicBezTo>
                      <a:pt x="151440" y="1697019"/>
                      <a:pt x="143307" y="1707522"/>
                      <a:pt x="138234" y="1719360"/>
                    </a:cubicBezTo>
                    <a:cubicBezTo>
                      <a:pt x="134647" y="1727731"/>
                      <a:pt x="132474" y="1736640"/>
                      <a:pt x="129594" y="1745280"/>
                    </a:cubicBezTo>
                    <a:cubicBezTo>
                      <a:pt x="120637" y="1825902"/>
                      <a:pt x="120955" y="1796961"/>
                      <a:pt x="120955" y="1831680"/>
                    </a:cubicBezTo>
                  </a:path>
                </a:pathLst>
              </a:custGeom>
              <a:ln w="38100" cmpd="sng">
                <a:solidFill>
                  <a:schemeClr val="tx1">
                    <a:lumMod val="95000"/>
                    <a:lumOff val="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4606163" y="3094082"/>
              <a:ext cx="2191714" cy="1828800"/>
              <a:chOff x="6483225" y="2209212"/>
              <a:chExt cx="2191714" cy="1828800"/>
            </a:xfrm>
          </p:grpSpPr>
          <p:pic>
            <p:nvPicPr>
              <p:cNvPr id="21" name="Picture 20" descr="PBS 1-1 o.jpg"/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33000"/>
                        </a14:imgEffect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83225" y="2209212"/>
                <a:ext cx="2191714" cy="1828800"/>
              </a:xfrm>
              <a:prstGeom prst="rect">
                <a:avLst/>
              </a:prstGeom>
            </p:spPr>
          </p:pic>
          <p:sp>
            <p:nvSpPr>
              <p:cNvPr id="22" name="Freeform 21"/>
              <p:cNvSpPr/>
              <p:nvPr/>
            </p:nvSpPr>
            <p:spPr>
              <a:xfrm>
                <a:off x="7030690" y="2217893"/>
                <a:ext cx="297998" cy="1816850"/>
              </a:xfrm>
              <a:custGeom>
                <a:avLst/>
                <a:gdLst>
                  <a:gd name="connsiteX0" fmla="*/ 170267 w 297998"/>
                  <a:gd name="connsiteY0" fmla="*/ 0 h 1816850"/>
                  <a:gd name="connsiteX1" fmla="*/ 188497 w 297998"/>
                  <a:gd name="connsiteY1" fmla="*/ 48612 h 1816850"/>
                  <a:gd name="connsiteX2" fmla="*/ 200651 w 297998"/>
                  <a:gd name="connsiteY2" fmla="*/ 85070 h 1816850"/>
                  <a:gd name="connsiteX3" fmla="*/ 206728 w 297998"/>
                  <a:gd name="connsiteY3" fmla="*/ 127605 h 1816850"/>
                  <a:gd name="connsiteX4" fmla="*/ 206728 w 297998"/>
                  <a:gd name="connsiteY4" fmla="*/ 206599 h 1816850"/>
                  <a:gd name="connsiteX5" fmla="*/ 182420 w 297998"/>
                  <a:gd name="connsiteY5" fmla="*/ 243057 h 1816850"/>
                  <a:gd name="connsiteX6" fmla="*/ 127730 w 297998"/>
                  <a:gd name="connsiteY6" fmla="*/ 291669 h 1816850"/>
                  <a:gd name="connsiteX7" fmla="*/ 109499 w 297998"/>
                  <a:gd name="connsiteY7" fmla="*/ 309898 h 1816850"/>
                  <a:gd name="connsiteX8" fmla="*/ 85192 w 297998"/>
                  <a:gd name="connsiteY8" fmla="*/ 346356 h 1816850"/>
                  <a:gd name="connsiteX9" fmla="*/ 54809 w 297998"/>
                  <a:gd name="connsiteY9" fmla="*/ 376739 h 1816850"/>
                  <a:gd name="connsiteX10" fmla="*/ 24425 w 297998"/>
                  <a:gd name="connsiteY10" fmla="*/ 413197 h 1816850"/>
                  <a:gd name="connsiteX11" fmla="*/ 12271 w 297998"/>
                  <a:gd name="connsiteY11" fmla="*/ 431426 h 1816850"/>
                  <a:gd name="connsiteX12" fmla="*/ 118 w 297998"/>
                  <a:gd name="connsiteY12" fmla="*/ 467885 h 1816850"/>
                  <a:gd name="connsiteX13" fmla="*/ 6195 w 297998"/>
                  <a:gd name="connsiteY13" fmla="*/ 528649 h 1816850"/>
                  <a:gd name="connsiteX14" fmla="*/ 36578 w 297998"/>
                  <a:gd name="connsiteY14" fmla="*/ 565108 h 1816850"/>
                  <a:gd name="connsiteX15" fmla="*/ 73039 w 297998"/>
                  <a:gd name="connsiteY15" fmla="*/ 583337 h 1816850"/>
                  <a:gd name="connsiteX16" fmla="*/ 109499 w 297998"/>
                  <a:gd name="connsiteY16" fmla="*/ 607642 h 1816850"/>
                  <a:gd name="connsiteX17" fmla="*/ 133806 w 297998"/>
                  <a:gd name="connsiteY17" fmla="*/ 644101 h 1816850"/>
                  <a:gd name="connsiteX18" fmla="*/ 158113 w 297998"/>
                  <a:gd name="connsiteY18" fmla="*/ 717018 h 1816850"/>
                  <a:gd name="connsiteX19" fmla="*/ 164190 w 297998"/>
                  <a:gd name="connsiteY19" fmla="*/ 735247 h 1816850"/>
                  <a:gd name="connsiteX20" fmla="*/ 176344 w 297998"/>
                  <a:gd name="connsiteY20" fmla="*/ 753477 h 1816850"/>
                  <a:gd name="connsiteX21" fmla="*/ 206728 w 297998"/>
                  <a:gd name="connsiteY21" fmla="*/ 808164 h 1816850"/>
                  <a:gd name="connsiteX22" fmla="*/ 218881 w 297998"/>
                  <a:gd name="connsiteY22" fmla="*/ 826394 h 1816850"/>
                  <a:gd name="connsiteX23" fmla="*/ 231035 w 297998"/>
                  <a:gd name="connsiteY23" fmla="*/ 862852 h 1816850"/>
                  <a:gd name="connsiteX24" fmla="*/ 243188 w 297998"/>
                  <a:gd name="connsiteY24" fmla="*/ 917540 h 1816850"/>
                  <a:gd name="connsiteX25" fmla="*/ 279649 w 297998"/>
                  <a:gd name="connsiteY25" fmla="*/ 947922 h 1816850"/>
                  <a:gd name="connsiteX26" fmla="*/ 285725 w 297998"/>
                  <a:gd name="connsiteY26" fmla="*/ 966151 h 1816850"/>
                  <a:gd name="connsiteX27" fmla="*/ 297879 w 297998"/>
                  <a:gd name="connsiteY27" fmla="*/ 984381 h 1816850"/>
                  <a:gd name="connsiteX28" fmla="*/ 285725 w 297998"/>
                  <a:gd name="connsiteY28" fmla="*/ 1051221 h 1816850"/>
                  <a:gd name="connsiteX29" fmla="*/ 249265 w 297998"/>
                  <a:gd name="connsiteY29" fmla="*/ 1093756 h 1816850"/>
                  <a:gd name="connsiteX30" fmla="*/ 212804 w 297998"/>
                  <a:gd name="connsiteY30" fmla="*/ 1124138 h 1816850"/>
                  <a:gd name="connsiteX31" fmla="*/ 200651 w 297998"/>
                  <a:gd name="connsiteY31" fmla="*/ 1160597 h 1816850"/>
                  <a:gd name="connsiteX32" fmla="*/ 188497 w 297998"/>
                  <a:gd name="connsiteY32" fmla="*/ 1245667 h 1816850"/>
                  <a:gd name="connsiteX33" fmla="*/ 182420 w 297998"/>
                  <a:gd name="connsiteY33" fmla="*/ 1263896 h 1816850"/>
                  <a:gd name="connsiteX34" fmla="*/ 158113 w 297998"/>
                  <a:gd name="connsiteY34" fmla="*/ 1300354 h 1816850"/>
                  <a:gd name="connsiteX35" fmla="*/ 121653 w 297998"/>
                  <a:gd name="connsiteY35" fmla="*/ 1324660 h 1816850"/>
                  <a:gd name="connsiteX36" fmla="*/ 103423 w 297998"/>
                  <a:gd name="connsiteY36" fmla="*/ 1367195 h 1816850"/>
                  <a:gd name="connsiteX37" fmla="*/ 109499 w 297998"/>
                  <a:gd name="connsiteY37" fmla="*/ 1385424 h 1816850"/>
                  <a:gd name="connsiteX38" fmla="*/ 127730 w 297998"/>
                  <a:gd name="connsiteY38" fmla="*/ 1446189 h 1816850"/>
                  <a:gd name="connsiteX39" fmla="*/ 133806 w 297998"/>
                  <a:gd name="connsiteY39" fmla="*/ 1464418 h 1816850"/>
                  <a:gd name="connsiteX40" fmla="*/ 139883 w 297998"/>
                  <a:gd name="connsiteY40" fmla="*/ 1482647 h 1816850"/>
                  <a:gd name="connsiteX41" fmla="*/ 127730 w 297998"/>
                  <a:gd name="connsiteY41" fmla="*/ 1549488 h 1816850"/>
                  <a:gd name="connsiteX42" fmla="*/ 103423 w 297998"/>
                  <a:gd name="connsiteY42" fmla="*/ 1585946 h 1816850"/>
                  <a:gd name="connsiteX43" fmla="*/ 91269 w 297998"/>
                  <a:gd name="connsiteY43" fmla="*/ 1622405 h 1816850"/>
                  <a:gd name="connsiteX44" fmla="*/ 73039 w 297998"/>
                  <a:gd name="connsiteY44" fmla="*/ 1640634 h 1816850"/>
                  <a:gd name="connsiteX45" fmla="*/ 60885 w 297998"/>
                  <a:gd name="connsiteY45" fmla="*/ 1658863 h 1816850"/>
                  <a:gd name="connsiteX46" fmla="*/ 42655 w 297998"/>
                  <a:gd name="connsiteY46" fmla="*/ 1671016 h 1816850"/>
                  <a:gd name="connsiteX47" fmla="*/ 30502 w 297998"/>
                  <a:gd name="connsiteY47" fmla="*/ 1689245 h 1816850"/>
                  <a:gd name="connsiteX48" fmla="*/ 42655 w 297998"/>
                  <a:gd name="connsiteY48" fmla="*/ 1756086 h 1816850"/>
                  <a:gd name="connsiteX49" fmla="*/ 54809 w 297998"/>
                  <a:gd name="connsiteY49" fmla="*/ 1792544 h 1816850"/>
                  <a:gd name="connsiteX50" fmla="*/ 66962 w 297998"/>
                  <a:gd name="connsiteY50" fmla="*/ 1816850 h 1816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</a:cxnLst>
                <a:rect l="l" t="t" r="r" b="b"/>
                <a:pathLst>
                  <a:path w="297998" h="1816850">
                    <a:moveTo>
                      <a:pt x="170267" y="0"/>
                    </a:moveTo>
                    <a:cubicBezTo>
                      <a:pt x="184673" y="72025"/>
                      <a:pt x="165738" y="-2592"/>
                      <a:pt x="188497" y="48612"/>
                    </a:cubicBezTo>
                    <a:cubicBezTo>
                      <a:pt x="193700" y="60318"/>
                      <a:pt x="200651" y="85070"/>
                      <a:pt x="200651" y="85070"/>
                    </a:cubicBezTo>
                    <a:cubicBezTo>
                      <a:pt x="202677" y="99248"/>
                      <a:pt x="204373" y="113478"/>
                      <a:pt x="206728" y="127605"/>
                    </a:cubicBezTo>
                    <a:cubicBezTo>
                      <a:pt x="212203" y="160452"/>
                      <a:pt x="220099" y="169161"/>
                      <a:pt x="206728" y="206599"/>
                    </a:cubicBezTo>
                    <a:cubicBezTo>
                      <a:pt x="201815" y="220354"/>
                      <a:pt x="194573" y="234955"/>
                      <a:pt x="182420" y="243057"/>
                    </a:cubicBezTo>
                    <a:cubicBezTo>
                      <a:pt x="149888" y="264745"/>
                      <a:pt x="169358" y="250044"/>
                      <a:pt x="127730" y="291669"/>
                    </a:cubicBezTo>
                    <a:lnTo>
                      <a:pt x="109499" y="309898"/>
                    </a:lnTo>
                    <a:cubicBezTo>
                      <a:pt x="98820" y="341935"/>
                      <a:pt x="110481" y="316010"/>
                      <a:pt x="85192" y="346356"/>
                    </a:cubicBezTo>
                    <a:cubicBezTo>
                      <a:pt x="59869" y="376742"/>
                      <a:pt x="88234" y="354456"/>
                      <a:pt x="54809" y="376739"/>
                    </a:cubicBezTo>
                    <a:cubicBezTo>
                      <a:pt x="24633" y="421998"/>
                      <a:pt x="63416" y="366411"/>
                      <a:pt x="24425" y="413197"/>
                    </a:cubicBezTo>
                    <a:cubicBezTo>
                      <a:pt x="19749" y="418807"/>
                      <a:pt x="16322" y="425350"/>
                      <a:pt x="12271" y="431426"/>
                    </a:cubicBezTo>
                    <a:cubicBezTo>
                      <a:pt x="8220" y="443579"/>
                      <a:pt x="-1157" y="455138"/>
                      <a:pt x="118" y="467885"/>
                    </a:cubicBezTo>
                    <a:cubicBezTo>
                      <a:pt x="2144" y="488140"/>
                      <a:pt x="1618" y="508815"/>
                      <a:pt x="6195" y="528649"/>
                    </a:cubicBezTo>
                    <a:cubicBezTo>
                      <a:pt x="8471" y="538511"/>
                      <a:pt x="30416" y="559974"/>
                      <a:pt x="36578" y="565108"/>
                    </a:cubicBezTo>
                    <a:cubicBezTo>
                      <a:pt x="68943" y="592077"/>
                      <a:pt x="40159" y="565071"/>
                      <a:pt x="73039" y="583337"/>
                    </a:cubicBezTo>
                    <a:cubicBezTo>
                      <a:pt x="85807" y="590430"/>
                      <a:pt x="109499" y="607642"/>
                      <a:pt x="109499" y="607642"/>
                    </a:cubicBezTo>
                    <a:cubicBezTo>
                      <a:pt x="117601" y="619795"/>
                      <a:pt x="129187" y="630244"/>
                      <a:pt x="133806" y="644101"/>
                    </a:cubicBezTo>
                    <a:lnTo>
                      <a:pt x="158113" y="717018"/>
                    </a:lnTo>
                    <a:cubicBezTo>
                      <a:pt x="160139" y="723094"/>
                      <a:pt x="160637" y="729918"/>
                      <a:pt x="164190" y="735247"/>
                    </a:cubicBezTo>
                    <a:lnTo>
                      <a:pt x="176344" y="753477"/>
                    </a:lnTo>
                    <a:cubicBezTo>
                      <a:pt x="187039" y="785564"/>
                      <a:pt x="178866" y="766373"/>
                      <a:pt x="206728" y="808164"/>
                    </a:cubicBezTo>
                    <a:cubicBezTo>
                      <a:pt x="210779" y="814240"/>
                      <a:pt x="216571" y="819466"/>
                      <a:pt x="218881" y="826394"/>
                    </a:cubicBezTo>
                    <a:lnTo>
                      <a:pt x="231035" y="862852"/>
                    </a:lnTo>
                    <a:cubicBezTo>
                      <a:pt x="231771" y="867267"/>
                      <a:pt x="236538" y="907566"/>
                      <a:pt x="243188" y="917540"/>
                    </a:cubicBezTo>
                    <a:cubicBezTo>
                      <a:pt x="252546" y="931577"/>
                      <a:pt x="266197" y="938955"/>
                      <a:pt x="279649" y="947922"/>
                    </a:cubicBezTo>
                    <a:cubicBezTo>
                      <a:pt x="281674" y="953998"/>
                      <a:pt x="282861" y="960422"/>
                      <a:pt x="285725" y="966151"/>
                    </a:cubicBezTo>
                    <a:cubicBezTo>
                      <a:pt x="288991" y="972683"/>
                      <a:pt x="297218" y="977108"/>
                      <a:pt x="297879" y="984381"/>
                    </a:cubicBezTo>
                    <a:cubicBezTo>
                      <a:pt x="298846" y="995018"/>
                      <a:pt x="293892" y="1034888"/>
                      <a:pt x="285725" y="1051221"/>
                    </a:cubicBezTo>
                    <a:cubicBezTo>
                      <a:pt x="277661" y="1067348"/>
                      <a:pt x="262348" y="1082543"/>
                      <a:pt x="249265" y="1093756"/>
                    </a:cubicBezTo>
                    <a:cubicBezTo>
                      <a:pt x="190027" y="1144529"/>
                      <a:pt x="276040" y="1060909"/>
                      <a:pt x="212804" y="1124138"/>
                    </a:cubicBezTo>
                    <a:cubicBezTo>
                      <a:pt x="208753" y="1136291"/>
                      <a:pt x="201926" y="1147850"/>
                      <a:pt x="200651" y="1160597"/>
                    </a:cubicBezTo>
                    <a:cubicBezTo>
                      <a:pt x="195808" y="1209020"/>
                      <a:pt x="198664" y="1210086"/>
                      <a:pt x="188497" y="1245667"/>
                    </a:cubicBezTo>
                    <a:cubicBezTo>
                      <a:pt x="186737" y="1251826"/>
                      <a:pt x="185531" y="1258297"/>
                      <a:pt x="182420" y="1263896"/>
                    </a:cubicBezTo>
                    <a:cubicBezTo>
                      <a:pt x="175326" y="1276664"/>
                      <a:pt x="170266" y="1292252"/>
                      <a:pt x="158113" y="1300354"/>
                    </a:cubicBezTo>
                    <a:lnTo>
                      <a:pt x="121653" y="1324660"/>
                    </a:lnTo>
                    <a:cubicBezTo>
                      <a:pt x="111728" y="1339545"/>
                      <a:pt x="103423" y="1347573"/>
                      <a:pt x="103423" y="1367195"/>
                    </a:cubicBezTo>
                    <a:cubicBezTo>
                      <a:pt x="103423" y="1373600"/>
                      <a:pt x="107739" y="1379265"/>
                      <a:pt x="109499" y="1385424"/>
                    </a:cubicBezTo>
                    <a:cubicBezTo>
                      <a:pt x="127864" y="1449699"/>
                      <a:pt x="98853" y="1359561"/>
                      <a:pt x="127730" y="1446189"/>
                    </a:cubicBezTo>
                    <a:lnTo>
                      <a:pt x="133806" y="1464418"/>
                    </a:lnTo>
                    <a:lnTo>
                      <a:pt x="139883" y="1482647"/>
                    </a:lnTo>
                    <a:cubicBezTo>
                      <a:pt x="138560" y="1493231"/>
                      <a:pt x="136793" y="1533175"/>
                      <a:pt x="127730" y="1549488"/>
                    </a:cubicBezTo>
                    <a:cubicBezTo>
                      <a:pt x="120637" y="1562256"/>
                      <a:pt x="108042" y="1572090"/>
                      <a:pt x="103423" y="1585946"/>
                    </a:cubicBezTo>
                    <a:cubicBezTo>
                      <a:pt x="99372" y="1598099"/>
                      <a:pt x="100328" y="1613347"/>
                      <a:pt x="91269" y="1622405"/>
                    </a:cubicBezTo>
                    <a:cubicBezTo>
                      <a:pt x="85192" y="1628481"/>
                      <a:pt x="78541" y="1634033"/>
                      <a:pt x="73039" y="1640634"/>
                    </a:cubicBezTo>
                    <a:cubicBezTo>
                      <a:pt x="68363" y="1646244"/>
                      <a:pt x="66049" y="1653699"/>
                      <a:pt x="60885" y="1658863"/>
                    </a:cubicBezTo>
                    <a:cubicBezTo>
                      <a:pt x="55721" y="1664027"/>
                      <a:pt x="48732" y="1666965"/>
                      <a:pt x="42655" y="1671016"/>
                    </a:cubicBezTo>
                    <a:cubicBezTo>
                      <a:pt x="38604" y="1677092"/>
                      <a:pt x="31229" y="1681978"/>
                      <a:pt x="30502" y="1689245"/>
                    </a:cubicBezTo>
                    <a:cubicBezTo>
                      <a:pt x="29325" y="1701016"/>
                      <a:pt x="38022" y="1740645"/>
                      <a:pt x="42655" y="1756086"/>
                    </a:cubicBezTo>
                    <a:cubicBezTo>
                      <a:pt x="46336" y="1768356"/>
                      <a:pt x="47703" y="1781885"/>
                      <a:pt x="54809" y="1792544"/>
                    </a:cubicBezTo>
                    <a:cubicBezTo>
                      <a:pt x="68085" y="1812459"/>
                      <a:pt x="66962" y="1803471"/>
                      <a:pt x="66962" y="1816850"/>
                    </a:cubicBezTo>
                  </a:path>
                </a:pathLst>
              </a:custGeom>
              <a:ln w="38100" cmpd="sng">
                <a:solidFill>
                  <a:srgbClr val="0D0D0D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Freeform 22"/>
              <p:cNvSpPr/>
              <p:nvPr/>
            </p:nvSpPr>
            <p:spPr>
              <a:xfrm>
                <a:off x="7571277" y="2213713"/>
                <a:ext cx="444145" cy="1807100"/>
              </a:xfrm>
              <a:custGeom>
                <a:avLst/>
                <a:gdLst>
                  <a:gd name="connsiteX0" fmla="*/ 263711 w 444145"/>
                  <a:gd name="connsiteY0" fmla="*/ 0 h 1686308"/>
                  <a:gd name="connsiteX1" fmla="*/ 256771 w 444145"/>
                  <a:gd name="connsiteY1" fmla="*/ 83275 h 1686308"/>
                  <a:gd name="connsiteX2" fmla="*/ 235952 w 444145"/>
                  <a:gd name="connsiteY2" fmla="*/ 104093 h 1686308"/>
                  <a:gd name="connsiteX3" fmla="*/ 194313 w 444145"/>
                  <a:gd name="connsiteY3" fmla="*/ 117972 h 1686308"/>
                  <a:gd name="connsiteX4" fmla="*/ 76337 w 444145"/>
                  <a:gd name="connsiteY4" fmla="*/ 131851 h 1686308"/>
                  <a:gd name="connsiteX5" fmla="*/ 48578 w 444145"/>
                  <a:gd name="connsiteY5" fmla="*/ 138791 h 1686308"/>
                  <a:gd name="connsiteX6" fmla="*/ 6940 w 444145"/>
                  <a:gd name="connsiteY6" fmla="*/ 152670 h 1686308"/>
                  <a:gd name="connsiteX7" fmla="*/ 0 w 444145"/>
                  <a:gd name="connsiteY7" fmla="*/ 173489 h 1686308"/>
                  <a:gd name="connsiteX8" fmla="*/ 20819 w 444145"/>
                  <a:gd name="connsiteY8" fmla="*/ 229005 h 1686308"/>
                  <a:gd name="connsiteX9" fmla="*/ 41639 w 444145"/>
                  <a:gd name="connsiteY9" fmla="*/ 242884 h 1686308"/>
                  <a:gd name="connsiteX10" fmla="*/ 62458 w 444145"/>
                  <a:gd name="connsiteY10" fmla="*/ 249824 h 1686308"/>
                  <a:gd name="connsiteX11" fmla="*/ 104096 w 444145"/>
                  <a:gd name="connsiteY11" fmla="*/ 277582 h 1686308"/>
                  <a:gd name="connsiteX12" fmla="*/ 145735 w 444145"/>
                  <a:gd name="connsiteY12" fmla="*/ 291461 h 1686308"/>
                  <a:gd name="connsiteX13" fmla="*/ 166554 w 444145"/>
                  <a:gd name="connsiteY13" fmla="*/ 305340 h 1686308"/>
                  <a:gd name="connsiteX14" fmla="*/ 187374 w 444145"/>
                  <a:gd name="connsiteY14" fmla="*/ 326158 h 1686308"/>
                  <a:gd name="connsiteX15" fmla="*/ 208193 w 444145"/>
                  <a:gd name="connsiteY15" fmla="*/ 333098 h 1686308"/>
                  <a:gd name="connsiteX16" fmla="*/ 222072 w 444145"/>
                  <a:gd name="connsiteY16" fmla="*/ 423312 h 1686308"/>
                  <a:gd name="connsiteX17" fmla="*/ 242892 w 444145"/>
                  <a:gd name="connsiteY17" fmla="*/ 464949 h 1686308"/>
                  <a:gd name="connsiteX18" fmla="*/ 263711 w 444145"/>
                  <a:gd name="connsiteY18" fmla="*/ 506587 h 1686308"/>
                  <a:gd name="connsiteX19" fmla="*/ 284530 w 444145"/>
                  <a:gd name="connsiteY19" fmla="*/ 527405 h 1686308"/>
                  <a:gd name="connsiteX20" fmla="*/ 298410 w 444145"/>
                  <a:gd name="connsiteY20" fmla="*/ 548224 h 1686308"/>
                  <a:gd name="connsiteX21" fmla="*/ 340048 w 444145"/>
                  <a:gd name="connsiteY21" fmla="*/ 575982 h 1686308"/>
                  <a:gd name="connsiteX22" fmla="*/ 367807 w 444145"/>
                  <a:gd name="connsiteY22" fmla="*/ 617619 h 1686308"/>
                  <a:gd name="connsiteX23" fmla="*/ 381687 w 444145"/>
                  <a:gd name="connsiteY23" fmla="*/ 638438 h 1686308"/>
                  <a:gd name="connsiteX24" fmla="*/ 388627 w 444145"/>
                  <a:gd name="connsiteY24" fmla="*/ 659256 h 1686308"/>
                  <a:gd name="connsiteX25" fmla="*/ 367807 w 444145"/>
                  <a:gd name="connsiteY25" fmla="*/ 673135 h 1686308"/>
                  <a:gd name="connsiteX26" fmla="*/ 270651 w 444145"/>
                  <a:gd name="connsiteY26" fmla="*/ 693954 h 1686308"/>
                  <a:gd name="connsiteX27" fmla="*/ 242892 w 444145"/>
                  <a:gd name="connsiteY27" fmla="*/ 735591 h 1686308"/>
                  <a:gd name="connsiteX28" fmla="*/ 215133 w 444145"/>
                  <a:gd name="connsiteY28" fmla="*/ 818866 h 1686308"/>
                  <a:gd name="connsiteX29" fmla="*/ 201253 w 444145"/>
                  <a:gd name="connsiteY29" fmla="*/ 860503 h 1686308"/>
                  <a:gd name="connsiteX30" fmla="*/ 194313 w 444145"/>
                  <a:gd name="connsiteY30" fmla="*/ 881322 h 1686308"/>
                  <a:gd name="connsiteX31" fmla="*/ 208193 w 444145"/>
                  <a:gd name="connsiteY31" fmla="*/ 978475 h 1686308"/>
                  <a:gd name="connsiteX32" fmla="*/ 222072 w 444145"/>
                  <a:gd name="connsiteY32" fmla="*/ 1027052 h 1686308"/>
                  <a:gd name="connsiteX33" fmla="*/ 235952 w 444145"/>
                  <a:gd name="connsiteY33" fmla="*/ 1047871 h 1686308"/>
                  <a:gd name="connsiteX34" fmla="*/ 298410 w 444145"/>
                  <a:gd name="connsiteY34" fmla="*/ 1040931 h 1686308"/>
                  <a:gd name="connsiteX35" fmla="*/ 319229 w 444145"/>
                  <a:gd name="connsiteY35" fmla="*/ 1027052 h 1686308"/>
                  <a:gd name="connsiteX36" fmla="*/ 346988 w 444145"/>
                  <a:gd name="connsiteY36" fmla="*/ 1020112 h 1686308"/>
                  <a:gd name="connsiteX37" fmla="*/ 388627 w 444145"/>
                  <a:gd name="connsiteY37" fmla="*/ 1027052 h 1686308"/>
                  <a:gd name="connsiteX38" fmla="*/ 409446 w 444145"/>
                  <a:gd name="connsiteY38" fmla="*/ 1040931 h 1686308"/>
                  <a:gd name="connsiteX39" fmla="*/ 430265 w 444145"/>
                  <a:gd name="connsiteY39" fmla="*/ 1047871 h 1686308"/>
                  <a:gd name="connsiteX40" fmla="*/ 444145 w 444145"/>
                  <a:gd name="connsiteY40" fmla="*/ 1068689 h 1686308"/>
                  <a:gd name="connsiteX41" fmla="*/ 409446 w 444145"/>
                  <a:gd name="connsiteY41" fmla="*/ 1117266 h 1686308"/>
                  <a:gd name="connsiteX42" fmla="*/ 388627 w 444145"/>
                  <a:gd name="connsiteY42" fmla="*/ 1131145 h 1686308"/>
                  <a:gd name="connsiteX43" fmla="*/ 333109 w 444145"/>
                  <a:gd name="connsiteY43" fmla="*/ 1165843 h 1686308"/>
                  <a:gd name="connsiteX44" fmla="*/ 312289 w 444145"/>
                  <a:gd name="connsiteY44" fmla="*/ 1172782 h 1686308"/>
                  <a:gd name="connsiteX45" fmla="*/ 291470 w 444145"/>
                  <a:gd name="connsiteY45" fmla="*/ 1186661 h 1686308"/>
                  <a:gd name="connsiteX46" fmla="*/ 270651 w 444145"/>
                  <a:gd name="connsiteY46" fmla="*/ 1193601 h 1686308"/>
                  <a:gd name="connsiteX47" fmla="*/ 222072 w 444145"/>
                  <a:gd name="connsiteY47" fmla="*/ 1256057 h 1686308"/>
                  <a:gd name="connsiteX48" fmla="*/ 201253 w 444145"/>
                  <a:gd name="connsiteY48" fmla="*/ 1276875 h 1686308"/>
                  <a:gd name="connsiteX49" fmla="*/ 159615 w 444145"/>
                  <a:gd name="connsiteY49" fmla="*/ 1297694 h 1686308"/>
                  <a:gd name="connsiteX50" fmla="*/ 117976 w 444145"/>
                  <a:gd name="connsiteY50" fmla="*/ 1332392 h 1686308"/>
                  <a:gd name="connsiteX51" fmla="*/ 131856 w 444145"/>
                  <a:gd name="connsiteY51" fmla="*/ 1394848 h 1686308"/>
                  <a:gd name="connsiteX52" fmla="*/ 145735 w 444145"/>
                  <a:gd name="connsiteY52" fmla="*/ 1415666 h 1686308"/>
                  <a:gd name="connsiteX53" fmla="*/ 159615 w 444145"/>
                  <a:gd name="connsiteY53" fmla="*/ 1457303 h 1686308"/>
                  <a:gd name="connsiteX54" fmla="*/ 180434 w 444145"/>
                  <a:gd name="connsiteY54" fmla="*/ 1554457 h 1686308"/>
                  <a:gd name="connsiteX55" fmla="*/ 194313 w 444145"/>
                  <a:gd name="connsiteY55" fmla="*/ 1603034 h 1686308"/>
                  <a:gd name="connsiteX56" fmla="*/ 235952 w 444145"/>
                  <a:gd name="connsiteY56" fmla="*/ 1623852 h 1686308"/>
                  <a:gd name="connsiteX57" fmla="*/ 256771 w 444145"/>
                  <a:gd name="connsiteY57" fmla="*/ 1637731 h 1686308"/>
                  <a:gd name="connsiteX58" fmla="*/ 277590 w 444145"/>
                  <a:gd name="connsiteY58" fmla="*/ 1686308 h 16863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</a:cxnLst>
                <a:rect l="l" t="t" r="r" b="b"/>
                <a:pathLst>
                  <a:path w="444145" h="1686308">
                    <a:moveTo>
                      <a:pt x="263711" y="0"/>
                    </a:moveTo>
                    <a:cubicBezTo>
                      <a:pt x="261398" y="27758"/>
                      <a:pt x="263948" y="56361"/>
                      <a:pt x="256771" y="83275"/>
                    </a:cubicBezTo>
                    <a:cubicBezTo>
                      <a:pt x="254242" y="92758"/>
                      <a:pt x="244531" y="99327"/>
                      <a:pt x="235952" y="104093"/>
                    </a:cubicBezTo>
                    <a:cubicBezTo>
                      <a:pt x="223163" y="111198"/>
                      <a:pt x="208744" y="115567"/>
                      <a:pt x="194313" y="117972"/>
                    </a:cubicBezTo>
                    <a:cubicBezTo>
                      <a:pt x="127472" y="129113"/>
                      <a:pt x="166688" y="123638"/>
                      <a:pt x="76337" y="131851"/>
                    </a:cubicBezTo>
                    <a:cubicBezTo>
                      <a:pt x="67084" y="134164"/>
                      <a:pt x="57714" y="136050"/>
                      <a:pt x="48578" y="138791"/>
                    </a:cubicBezTo>
                    <a:cubicBezTo>
                      <a:pt x="34565" y="142995"/>
                      <a:pt x="6940" y="152670"/>
                      <a:pt x="6940" y="152670"/>
                    </a:cubicBezTo>
                    <a:cubicBezTo>
                      <a:pt x="4627" y="159610"/>
                      <a:pt x="0" y="166174"/>
                      <a:pt x="0" y="173489"/>
                    </a:cubicBezTo>
                    <a:cubicBezTo>
                      <a:pt x="0" y="193347"/>
                      <a:pt x="6462" y="214648"/>
                      <a:pt x="20819" y="229005"/>
                    </a:cubicBezTo>
                    <a:cubicBezTo>
                      <a:pt x="26717" y="234903"/>
                      <a:pt x="34179" y="239154"/>
                      <a:pt x="41639" y="242884"/>
                    </a:cubicBezTo>
                    <a:cubicBezTo>
                      <a:pt x="48182" y="246155"/>
                      <a:pt x="56063" y="246272"/>
                      <a:pt x="62458" y="249824"/>
                    </a:cubicBezTo>
                    <a:cubicBezTo>
                      <a:pt x="77040" y="257925"/>
                      <a:pt x="88271" y="272307"/>
                      <a:pt x="104096" y="277582"/>
                    </a:cubicBezTo>
                    <a:cubicBezTo>
                      <a:pt x="117976" y="282208"/>
                      <a:pt x="133562" y="283346"/>
                      <a:pt x="145735" y="291461"/>
                    </a:cubicBezTo>
                    <a:cubicBezTo>
                      <a:pt x="152675" y="296087"/>
                      <a:pt x="160147" y="300001"/>
                      <a:pt x="166554" y="305340"/>
                    </a:cubicBezTo>
                    <a:cubicBezTo>
                      <a:pt x="174094" y="311623"/>
                      <a:pt x="179208" y="320714"/>
                      <a:pt x="187374" y="326158"/>
                    </a:cubicBezTo>
                    <a:cubicBezTo>
                      <a:pt x="193461" y="330216"/>
                      <a:pt x="201253" y="330785"/>
                      <a:pt x="208193" y="333098"/>
                    </a:cubicBezTo>
                    <a:cubicBezTo>
                      <a:pt x="224898" y="383209"/>
                      <a:pt x="206737" y="323636"/>
                      <a:pt x="222072" y="423312"/>
                    </a:cubicBezTo>
                    <a:cubicBezTo>
                      <a:pt x="224945" y="441988"/>
                      <a:pt x="232598" y="449510"/>
                      <a:pt x="242892" y="464949"/>
                    </a:cubicBezTo>
                    <a:cubicBezTo>
                      <a:pt x="249847" y="485816"/>
                      <a:pt x="248762" y="488649"/>
                      <a:pt x="263711" y="506587"/>
                    </a:cubicBezTo>
                    <a:cubicBezTo>
                      <a:pt x="269994" y="514126"/>
                      <a:pt x="278247" y="519866"/>
                      <a:pt x="284530" y="527405"/>
                    </a:cubicBezTo>
                    <a:cubicBezTo>
                      <a:pt x="289870" y="533812"/>
                      <a:pt x="292133" y="542732"/>
                      <a:pt x="298410" y="548224"/>
                    </a:cubicBezTo>
                    <a:cubicBezTo>
                      <a:pt x="310964" y="559208"/>
                      <a:pt x="340048" y="575982"/>
                      <a:pt x="340048" y="575982"/>
                    </a:cubicBezTo>
                    <a:lnTo>
                      <a:pt x="367807" y="617619"/>
                    </a:lnTo>
                    <a:cubicBezTo>
                      <a:pt x="372434" y="624559"/>
                      <a:pt x="379049" y="630526"/>
                      <a:pt x="381687" y="638438"/>
                    </a:cubicBezTo>
                    <a:lnTo>
                      <a:pt x="388627" y="659256"/>
                    </a:lnTo>
                    <a:cubicBezTo>
                      <a:pt x="381687" y="663882"/>
                      <a:pt x="375963" y="671387"/>
                      <a:pt x="367807" y="673135"/>
                    </a:cubicBezTo>
                    <a:cubicBezTo>
                      <a:pt x="260080" y="696219"/>
                      <a:pt x="320265" y="660879"/>
                      <a:pt x="270651" y="693954"/>
                    </a:cubicBezTo>
                    <a:cubicBezTo>
                      <a:pt x="261398" y="707833"/>
                      <a:pt x="248167" y="719766"/>
                      <a:pt x="242892" y="735591"/>
                    </a:cubicBezTo>
                    <a:lnTo>
                      <a:pt x="215133" y="818866"/>
                    </a:lnTo>
                    <a:lnTo>
                      <a:pt x="201253" y="860503"/>
                    </a:lnTo>
                    <a:lnTo>
                      <a:pt x="194313" y="881322"/>
                    </a:lnTo>
                    <a:cubicBezTo>
                      <a:pt x="198578" y="915436"/>
                      <a:pt x="201522" y="945124"/>
                      <a:pt x="208193" y="978475"/>
                    </a:cubicBezTo>
                    <a:cubicBezTo>
                      <a:pt x="209674" y="985880"/>
                      <a:pt x="217665" y="1018238"/>
                      <a:pt x="222072" y="1027052"/>
                    </a:cubicBezTo>
                    <a:cubicBezTo>
                      <a:pt x="225802" y="1034512"/>
                      <a:pt x="231325" y="1040931"/>
                      <a:pt x="235952" y="1047871"/>
                    </a:cubicBezTo>
                    <a:cubicBezTo>
                      <a:pt x="256771" y="1045558"/>
                      <a:pt x="278088" y="1046011"/>
                      <a:pt x="298410" y="1040931"/>
                    </a:cubicBezTo>
                    <a:cubicBezTo>
                      <a:pt x="306501" y="1038908"/>
                      <a:pt x="311563" y="1030337"/>
                      <a:pt x="319229" y="1027052"/>
                    </a:cubicBezTo>
                    <a:cubicBezTo>
                      <a:pt x="327996" y="1023295"/>
                      <a:pt x="337735" y="1022425"/>
                      <a:pt x="346988" y="1020112"/>
                    </a:cubicBezTo>
                    <a:cubicBezTo>
                      <a:pt x="360868" y="1022425"/>
                      <a:pt x="375278" y="1022602"/>
                      <a:pt x="388627" y="1027052"/>
                    </a:cubicBezTo>
                    <a:cubicBezTo>
                      <a:pt x="396539" y="1029689"/>
                      <a:pt x="401986" y="1037201"/>
                      <a:pt x="409446" y="1040931"/>
                    </a:cubicBezTo>
                    <a:cubicBezTo>
                      <a:pt x="415989" y="1044202"/>
                      <a:pt x="423325" y="1045558"/>
                      <a:pt x="430265" y="1047871"/>
                    </a:cubicBezTo>
                    <a:cubicBezTo>
                      <a:pt x="434892" y="1054810"/>
                      <a:pt x="444145" y="1060349"/>
                      <a:pt x="444145" y="1068689"/>
                    </a:cubicBezTo>
                    <a:cubicBezTo>
                      <a:pt x="444145" y="1120734"/>
                      <a:pt x="436047" y="1103965"/>
                      <a:pt x="409446" y="1117266"/>
                    </a:cubicBezTo>
                    <a:cubicBezTo>
                      <a:pt x="401986" y="1120996"/>
                      <a:pt x="395567" y="1126519"/>
                      <a:pt x="388627" y="1131145"/>
                    </a:cubicBezTo>
                    <a:cubicBezTo>
                      <a:pt x="366632" y="1164136"/>
                      <a:pt x="382659" y="1149327"/>
                      <a:pt x="333109" y="1165843"/>
                    </a:cubicBezTo>
                    <a:lnTo>
                      <a:pt x="312289" y="1172782"/>
                    </a:lnTo>
                    <a:cubicBezTo>
                      <a:pt x="305349" y="1177408"/>
                      <a:pt x="298930" y="1182931"/>
                      <a:pt x="291470" y="1186661"/>
                    </a:cubicBezTo>
                    <a:cubicBezTo>
                      <a:pt x="284927" y="1189932"/>
                      <a:pt x="276738" y="1189543"/>
                      <a:pt x="270651" y="1193601"/>
                    </a:cubicBezTo>
                    <a:cubicBezTo>
                      <a:pt x="241344" y="1213139"/>
                      <a:pt x="249652" y="1228478"/>
                      <a:pt x="222072" y="1256057"/>
                    </a:cubicBezTo>
                    <a:cubicBezTo>
                      <a:pt x="215132" y="1262996"/>
                      <a:pt x="208792" y="1270592"/>
                      <a:pt x="201253" y="1276875"/>
                    </a:cubicBezTo>
                    <a:cubicBezTo>
                      <a:pt x="171422" y="1301733"/>
                      <a:pt x="190912" y="1282046"/>
                      <a:pt x="159615" y="1297694"/>
                    </a:cubicBezTo>
                    <a:cubicBezTo>
                      <a:pt x="140289" y="1307357"/>
                      <a:pt x="133326" y="1317042"/>
                      <a:pt x="117976" y="1332392"/>
                    </a:cubicBezTo>
                    <a:cubicBezTo>
                      <a:pt x="120642" y="1348385"/>
                      <a:pt x="123314" y="1377764"/>
                      <a:pt x="131856" y="1394848"/>
                    </a:cubicBezTo>
                    <a:cubicBezTo>
                      <a:pt x="135586" y="1402308"/>
                      <a:pt x="142348" y="1408045"/>
                      <a:pt x="145735" y="1415666"/>
                    </a:cubicBezTo>
                    <a:cubicBezTo>
                      <a:pt x="151677" y="1429035"/>
                      <a:pt x="159615" y="1457303"/>
                      <a:pt x="159615" y="1457303"/>
                    </a:cubicBezTo>
                    <a:cubicBezTo>
                      <a:pt x="174669" y="1577750"/>
                      <a:pt x="155713" y="1455581"/>
                      <a:pt x="180434" y="1554457"/>
                    </a:cubicBezTo>
                    <a:cubicBezTo>
                      <a:pt x="180886" y="1556267"/>
                      <a:pt x="190695" y="1598511"/>
                      <a:pt x="194313" y="1603034"/>
                    </a:cubicBezTo>
                    <a:cubicBezTo>
                      <a:pt x="204097" y="1615263"/>
                      <a:pt x="222238" y="1619281"/>
                      <a:pt x="235952" y="1623852"/>
                    </a:cubicBezTo>
                    <a:cubicBezTo>
                      <a:pt x="242892" y="1628478"/>
                      <a:pt x="252351" y="1630658"/>
                      <a:pt x="256771" y="1637731"/>
                    </a:cubicBezTo>
                    <a:cubicBezTo>
                      <a:pt x="306486" y="1717272"/>
                      <a:pt x="252525" y="1661243"/>
                      <a:pt x="277590" y="1686308"/>
                    </a:cubicBezTo>
                  </a:path>
                </a:pathLst>
              </a:custGeom>
              <a:ln w="38100" cmpd="sng">
                <a:solidFill>
                  <a:srgbClr val="0D0D0D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78013" y="3106413"/>
              <a:ext cx="2191714" cy="1828800"/>
              <a:chOff x="766781" y="3106413"/>
              <a:chExt cx="2191714" cy="1828800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766781" y="3106413"/>
                <a:ext cx="2191714" cy="1828800"/>
                <a:chOff x="3597257" y="251370"/>
                <a:chExt cx="2191714" cy="1828800"/>
              </a:xfrm>
            </p:grpSpPr>
            <p:pic>
              <p:nvPicPr>
                <p:cNvPr id="27" name="Picture 26" descr="PBS 1-2 ooo.jpg"/>
                <p:cNvPicPr>
                  <a:picLocks noChangeAspect="1"/>
                </p:cNvPicPr>
                <p:nvPr/>
              </p:nvPicPr>
              <p:blipFill>
                <a:blip r:embed="rId10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97257" y="251370"/>
                  <a:ext cx="2191714" cy="1828800"/>
                </a:xfrm>
                <a:prstGeom prst="rect">
                  <a:avLst/>
                </a:prstGeom>
              </p:spPr>
            </p:pic>
            <p:sp>
              <p:nvSpPr>
                <p:cNvPr id="28" name="Freeform 27"/>
                <p:cNvSpPr/>
                <p:nvPr/>
              </p:nvSpPr>
              <p:spPr>
                <a:xfrm>
                  <a:off x="4271573" y="251910"/>
                  <a:ext cx="272877" cy="1826351"/>
                </a:xfrm>
                <a:custGeom>
                  <a:avLst/>
                  <a:gdLst>
                    <a:gd name="connsiteX0" fmla="*/ 272877 w 272877"/>
                    <a:gd name="connsiteY0" fmla="*/ 0 h 1826351"/>
                    <a:gd name="connsiteX1" fmla="*/ 262382 w 272877"/>
                    <a:gd name="connsiteY1" fmla="*/ 94467 h 1826351"/>
                    <a:gd name="connsiteX2" fmla="*/ 241391 w 272877"/>
                    <a:gd name="connsiteY2" fmla="*/ 167941 h 1826351"/>
                    <a:gd name="connsiteX3" fmla="*/ 220401 w 272877"/>
                    <a:gd name="connsiteY3" fmla="*/ 272903 h 1826351"/>
                    <a:gd name="connsiteX4" fmla="*/ 188915 w 272877"/>
                    <a:gd name="connsiteY4" fmla="*/ 335881 h 1826351"/>
                    <a:gd name="connsiteX5" fmla="*/ 178420 w 272877"/>
                    <a:gd name="connsiteY5" fmla="*/ 367370 h 1826351"/>
                    <a:gd name="connsiteX6" fmla="*/ 167924 w 272877"/>
                    <a:gd name="connsiteY6" fmla="*/ 440844 h 1826351"/>
                    <a:gd name="connsiteX7" fmla="*/ 136438 w 272877"/>
                    <a:gd name="connsiteY7" fmla="*/ 535310 h 1826351"/>
                    <a:gd name="connsiteX8" fmla="*/ 125943 w 272877"/>
                    <a:gd name="connsiteY8" fmla="*/ 566799 h 1826351"/>
                    <a:gd name="connsiteX9" fmla="*/ 115448 w 272877"/>
                    <a:gd name="connsiteY9" fmla="*/ 598288 h 1826351"/>
                    <a:gd name="connsiteX10" fmla="*/ 94457 w 272877"/>
                    <a:gd name="connsiteY10" fmla="*/ 629777 h 1826351"/>
                    <a:gd name="connsiteX11" fmla="*/ 83962 w 272877"/>
                    <a:gd name="connsiteY11" fmla="*/ 661265 h 1826351"/>
                    <a:gd name="connsiteX12" fmla="*/ 62972 w 272877"/>
                    <a:gd name="connsiteY12" fmla="*/ 692754 h 1826351"/>
                    <a:gd name="connsiteX13" fmla="*/ 41981 w 272877"/>
                    <a:gd name="connsiteY13" fmla="*/ 755732 h 1826351"/>
                    <a:gd name="connsiteX14" fmla="*/ 31486 w 272877"/>
                    <a:gd name="connsiteY14" fmla="*/ 787221 h 1826351"/>
                    <a:gd name="connsiteX15" fmla="*/ 20991 w 272877"/>
                    <a:gd name="connsiteY15" fmla="*/ 818709 h 1826351"/>
                    <a:gd name="connsiteX16" fmla="*/ 31486 w 272877"/>
                    <a:gd name="connsiteY16" fmla="*/ 902680 h 1826351"/>
                    <a:gd name="connsiteX17" fmla="*/ 41981 w 272877"/>
                    <a:gd name="connsiteY17" fmla="*/ 934168 h 1826351"/>
                    <a:gd name="connsiteX18" fmla="*/ 52476 w 272877"/>
                    <a:gd name="connsiteY18" fmla="*/ 986650 h 1826351"/>
                    <a:gd name="connsiteX19" fmla="*/ 41981 w 272877"/>
                    <a:gd name="connsiteY19" fmla="*/ 1039131 h 1826351"/>
                    <a:gd name="connsiteX20" fmla="*/ 20991 w 272877"/>
                    <a:gd name="connsiteY20" fmla="*/ 1102109 h 1826351"/>
                    <a:gd name="connsiteX21" fmla="*/ 0 w 272877"/>
                    <a:gd name="connsiteY21" fmla="*/ 1238560 h 1826351"/>
                    <a:gd name="connsiteX22" fmla="*/ 20991 w 272877"/>
                    <a:gd name="connsiteY22" fmla="*/ 1458982 h 1826351"/>
                    <a:gd name="connsiteX23" fmla="*/ 31486 w 272877"/>
                    <a:gd name="connsiteY23" fmla="*/ 1532456 h 1826351"/>
                    <a:gd name="connsiteX24" fmla="*/ 52476 w 272877"/>
                    <a:gd name="connsiteY24" fmla="*/ 1658411 h 1826351"/>
                    <a:gd name="connsiteX25" fmla="*/ 62972 w 272877"/>
                    <a:gd name="connsiteY25" fmla="*/ 1731885 h 1826351"/>
                    <a:gd name="connsiteX26" fmla="*/ 52476 w 272877"/>
                    <a:gd name="connsiteY26" fmla="*/ 1815855 h 1826351"/>
                    <a:gd name="connsiteX27" fmla="*/ 52476 w 272877"/>
                    <a:gd name="connsiteY27" fmla="*/ 1826351 h 18263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</a:cxnLst>
                  <a:rect l="l" t="t" r="r" b="b"/>
                  <a:pathLst>
                    <a:path w="272877" h="1826351">
                      <a:moveTo>
                        <a:pt x="272877" y="0"/>
                      </a:moveTo>
                      <a:cubicBezTo>
                        <a:pt x="269379" y="31489"/>
                        <a:pt x="267199" y="63153"/>
                        <a:pt x="262382" y="94467"/>
                      </a:cubicBezTo>
                      <a:cubicBezTo>
                        <a:pt x="250955" y="168749"/>
                        <a:pt x="255103" y="106228"/>
                        <a:pt x="241391" y="167941"/>
                      </a:cubicBezTo>
                      <a:cubicBezTo>
                        <a:pt x="220779" y="260706"/>
                        <a:pt x="241307" y="199725"/>
                        <a:pt x="220401" y="272903"/>
                      </a:cubicBezTo>
                      <a:cubicBezTo>
                        <a:pt x="202814" y="334462"/>
                        <a:pt x="219578" y="274547"/>
                        <a:pt x="188915" y="335881"/>
                      </a:cubicBezTo>
                      <a:cubicBezTo>
                        <a:pt x="183968" y="345777"/>
                        <a:pt x="181918" y="356874"/>
                        <a:pt x="178420" y="367370"/>
                      </a:cubicBezTo>
                      <a:cubicBezTo>
                        <a:pt x="174921" y="391861"/>
                        <a:pt x="173487" y="416737"/>
                        <a:pt x="167924" y="440844"/>
                      </a:cubicBezTo>
                      <a:cubicBezTo>
                        <a:pt x="167919" y="440868"/>
                        <a:pt x="141689" y="519554"/>
                        <a:pt x="136438" y="535310"/>
                      </a:cubicBezTo>
                      <a:lnTo>
                        <a:pt x="125943" y="566799"/>
                      </a:lnTo>
                      <a:cubicBezTo>
                        <a:pt x="122445" y="577295"/>
                        <a:pt x="121585" y="589082"/>
                        <a:pt x="115448" y="598288"/>
                      </a:cubicBezTo>
                      <a:lnTo>
                        <a:pt x="94457" y="629777"/>
                      </a:lnTo>
                      <a:cubicBezTo>
                        <a:pt x="90959" y="640273"/>
                        <a:pt x="88909" y="651369"/>
                        <a:pt x="83962" y="661265"/>
                      </a:cubicBezTo>
                      <a:cubicBezTo>
                        <a:pt x="78321" y="672548"/>
                        <a:pt x="68095" y="681227"/>
                        <a:pt x="62972" y="692754"/>
                      </a:cubicBezTo>
                      <a:cubicBezTo>
                        <a:pt x="53986" y="712975"/>
                        <a:pt x="48978" y="734739"/>
                        <a:pt x="41981" y="755732"/>
                      </a:cubicBezTo>
                      <a:lnTo>
                        <a:pt x="31486" y="787221"/>
                      </a:lnTo>
                      <a:lnTo>
                        <a:pt x="20991" y="818709"/>
                      </a:lnTo>
                      <a:cubicBezTo>
                        <a:pt x="24489" y="846699"/>
                        <a:pt x="26441" y="874927"/>
                        <a:pt x="31486" y="902680"/>
                      </a:cubicBezTo>
                      <a:cubicBezTo>
                        <a:pt x="33465" y="913565"/>
                        <a:pt x="39298" y="923435"/>
                        <a:pt x="41981" y="934168"/>
                      </a:cubicBezTo>
                      <a:cubicBezTo>
                        <a:pt x="46307" y="951476"/>
                        <a:pt x="48978" y="969156"/>
                        <a:pt x="52476" y="986650"/>
                      </a:cubicBezTo>
                      <a:cubicBezTo>
                        <a:pt x="48978" y="1004144"/>
                        <a:pt x="46674" y="1021919"/>
                        <a:pt x="41981" y="1039131"/>
                      </a:cubicBezTo>
                      <a:cubicBezTo>
                        <a:pt x="36159" y="1060479"/>
                        <a:pt x="24629" y="1080282"/>
                        <a:pt x="20991" y="1102109"/>
                      </a:cubicBezTo>
                      <a:cubicBezTo>
                        <a:pt x="6428" y="1189489"/>
                        <a:pt x="13504" y="1144018"/>
                        <a:pt x="0" y="1238560"/>
                      </a:cubicBezTo>
                      <a:cubicBezTo>
                        <a:pt x="27894" y="1461738"/>
                        <a:pt x="-10657" y="1142480"/>
                        <a:pt x="20991" y="1458982"/>
                      </a:cubicBezTo>
                      <a:cubicBezTo>
                        <a:pt x="23453" y="1483599"/>
                        <a:pt x="28418" y="1507907"/>
                        <a:pt x="31486" y="1532456"/>
                      </a:cubicBezTo>
                      <a:cubicBezTo>
                        <a:pt x="45546" y="1644949"/>
                        <a:pt x="31145" y="1594410"/>
                        <a:pt x="52476" y="1658411"/>
                      </a:cubicBezTo>
                      <a:cubicBezTo>
                        <a:pt x="55975" y="1682902"/>
                        <a:pt x="62972" y="1707145"/>
                        <a:pt x="62972" y="1731885"/>
                      </a:cubicBezTo>
                      <a:cubicBezTo>
                        <a:pt x="62972" y="1760093"/>
                        <a:pt x="55591" y="1787820"/>
                        <a:pt x="52476" y="1815855"/>
                      </a:cubicBezTo>
                      <a:cubicBezTo>
                        <a:pt x="52090" y="1819332"/>
                        <a:pt x="52476" y="1822852"/>
                        <a:pt x="52476" y="1826351"/>
                      </a:cubicBezTo>
                    </a:path>
                  </a:pathLst>
                </a:custGeom>
                <a:ln w="38100" cmpd="sng">
                  <a:solidFill>
                    <a:schemeClr val="tx1">
                      <a:lumMod val="95000"/>
                      <a:lumOff val="5000"/>
                    </a:schemeClr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6" name="Freeform 25"/>
              <p:cNvSpPr/>
              <p:nvPr/>
            </p:nvSpPr>
            <p:spPr>
              <a:xfrm>
                <a:off x="1807308" y="3126154"/>
                <a:ext cx="351692" cy="1807307"/>
              </a:xfrm>
              <a:custGeom>
                <a:avLst/>
                <a:gdLst>
                  <a:gd name="connsiteX0" fmla="*/ 351692 w 351692"/>
                  <a:gd name="connsiteY0" fmla="*/ 0 h 1807307"/>
                  <a:gd name="connsiteX1" fmla="*/ 302846 w 351692"/>
                  <a:gd name="connsiteY1" fmla="*/ 87923 h 1807307"/>
                  <a:gd name="connsiteX2" fmla="*/ 283307 w 351692"/>
                  <a:gd name="connsiteY2" fmla="*/ 107461 h 1807307"/>
                  <a:gd name="connsiteX3" fmla="*/ 263769 w 351692"/>
                  <a:gd name="connsiteY3" fmla="*/ 127000 h 1807307"/>
                  <a:gd name="connsiteX4" fmla="*/ 234461 w 351692"/>
                  <a:gd name="connsiteY4" fmla="*/ 214923 h 1807307"/>
                  <a:gd name="connsiteX5" fmla="*/ 224692 w 351692"/>
                  <a:gd name="connsiteY5" fmla="*/ 244230 h 1807307"/>
                  <a:gd name="connsiteX6" fmla="*/ 205154 w 351692"/>
                  <a:gd name="connsiteY6" fmla="*/ 273538 h 1807307"/>
                  <a:gd name="connsiteX7" fmla="*/ 185615 w 351692"/>
                  <a:gd name="connsiteY7" fmla="*/ 332153 h 1807307"/>
                  <a:gd name="connsiteX8" fmla="*/ 175846 w 351692"/>
                  <a:gd name="connsiteY8" fmla="*/ 361461 h 1807307"/>
                  <a:gd name="connsiteX9" fmla="*/ 156307 w 351692"/>
                  <a:gd name="connsiteY9" fmla="*/ 381000 h 1807307"/>
                  <a:gd name="connsiteX10" fmla="*/ 107461 w 351692"/>
                  <a:gd name="connsiteY10" fmla="*/ 449384 h 1807307"/>
                  <a:gd name="connsiteX11" fmla="*/ 87923 w 351692"/>
                  <a:gd name="connsiteY11" fmla="*/ 468923 h 1807307"/>
                  <a:gd name="connsiteX12" fmla="*/ 68384 w 351692"/>
                  <a:gd name="connsiteY12" fmla="*/ 527538 h 1807307"/>
                  <a:gd name="connsiteX13" fmla="*/ 107461 w 351692"/>
                  <a:gd name="connsiteY13" fmla="*/ 586153 h 1807307"/>
                  <a:gd name="connsiteX14" fmla="*/ 127000 w 351692"/>
                  <a:gd name="connsiteY14" fmla="*/ 605692 h 1807307"/>
                  <a:gd name="connsiteX15" fmla="*/ 185615 w 351692"/>
                  <a:gd name="connsiteY15" fmla="*/ 625230 h 1807307"/>
                  <a:gd name="connsiteX16" fmla="*/ 214923 w 351692"/>
                  <a:gd name="connsiteY16" fmla="*/ 635000 h 1807307"/>
                  <a:gd name="connsiteX17" fmla="*/ 244230 w 351692"/>
                  <a:gd name="connsiteY17" fmla="*/ 644769 h 1807307"/>
                  <a:gd name="connsiteX18" fmla="*/ 263769 w 351692"/>
                  <a:gd name="connsiteY18" fmla="*/ 722923 h 1807307"/>
                  <a:gd name="connsiteX19" fmla="*/ 254000 w 351692"/>
                  <a:gd name="connsiteY19" fmla="*/ 801077 h 1807307"/>
                  <a:gd name="connsiteX20" fmla="*/ 244230 w 351692"/>
                  <a:gd name="connsiteY20" fmla="*/ 830384 h 1807307"/>
                  <a:gd name="connsiteX21" fmla="*/ 185615 w 351692"/>
                  <a:gd name="connsiteY21" fmla="*/ 849923 h 1807307"/>
                  <a:gd name="connsiteX22" fmla="*/ 156307 w 351692"/>
                  <a:gd name="connsiteY22" fmla="*/ 859692 h 1807307"/>
                  <a:gd name="connsiteX23" fmla="*/ 127000 w 351692"/>
                  <a:gd name="connsiteY23" fmla="*/ 879230 h 1807307"/>
                  <a:gd name="connsiteX24" fmla="*/ 107461 w 351692"/>
                  <a:gd name="connsiteY24" fmla="*/ 937846 h 1807307"/>
                  <a:gd name="connsiteX25" fmla="*/ 97692 w 351692"/>
                  <a:gd name="connsiteY25" fmla="*/ 1045307 h 1807307"/>
                  <a:gd name="connsiteX26" fmla="*/ 78154 w 351692"/>
                  <a:gd name="connsiteY26" fmla="*/ 1103923 h 1807307"/>
                  <a:gd name="connsiteX27" fmla="*/ 68384 w 351692"/>
                  <a:gd name="connsiteY27" fmla="*/ 1133230 h 1807307"/>
                  <a:gd name="connsiteX28" fmla="*/ 58615 w 351692"/>
                  <a:gd name="connsiteY28" fmla="*/ 1230923 h 1807307"/>
                  <a:gd name="connsiteX29" fmla="*/ 39077 w 351692"/>
                  <a:gd name="connsiteY29" fmla="*/ 1309077 h 1807307"/>
                  <a:gd name="connsiteX30" fmla="*/ 29307 w 351692"/>
                  <a:gd name="connsiteY30" fmla="*/ 1357923 h 1807307"/>
                  <a:gd name="connsiteX31" fmla="*/ 39077 w 351692"/>
                  <a:gd name="connsiteY31" fmla="*/ 1416538 h 1807307"/>
                  <a:gd name="connsiteX32" fmla="*/ 48846 w 351692"/>
                  <a:gd name="connsiteY32" fmla="*/ 1445846 h 1807307"/>
                  <a:gd name="connsiteX33" fmla="*/ 29307 w 351692"/>
                  <a:gd name="connsiteY33" fmla="*/ 1553307 h 1807307"/>
                  <a:gd name="connsiteX34" fmla="*/ 9769 w 351692"/>
                  <a:gd name="connsiteY34" fmla="*/ 1572846 h 1807307"/>
                  <a:gd name="connsiteX35" fmla="*/ 0 w 351692"/>
                  <a:gd name="connsiteY35" fmla="*/ 1651000 h 1807307"/>
                  <a:gd name="connsiteX36" fmla="*/ 19538 w 351692"/>
                  <a:gd name="connsiteY36" fmla="*/ 1778000 h 1807307"/>
                  <a:gd name="connsiteX37" fmla="*/ 19538 w 351692"/>
                  <a:gd name="connsiteY37" fmla="*/ 1807307 h 18073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</a:cxnLst>
                <a:rect l="l" t="t" r="r" b="b"/>
                <a:pathLst>
                  <a:path w="351692" h="1807307">
                    <a:moveTo>
                      <a:pt x="351692" y="0"/>
                    </a:moveTo>
                    <a:cubicBezTo>
                      <a:pt x="338311" y="66908"/>
                      <a:pt x="353664" y="37106"/>
                      <a:pt x="302846" y="87923"/>
                    </a:cubicBezTo>
                    <a:lnTo>
                      <a:pt x="283307" y="107461"/>
                    </a:lnTo>
                    <a:lnTo>
                      <a:pt x="263769" y="127000"/>
                    </a:lnTo>
                    <a:lnTo>
                      <a:pt x="234461" y="214923"/>
                    </a:lnTo>
                    <a:cubicBezTo>
                      <a:pt x="231205" y="224692"/>
                      <a:pt x="230404" y="235662"/>
                      <a:pt x="224692" y="244230"/>
                    </a:cubicBezTo>
                    <a:cubicBezTo>
                      <a:pt x="218179" y="253999"/>
                      <a:pt x="209923" y="262809"/>
                      <a:pt x="205154" y="273538"/>
                    </a:cubicBezTo>
                    <a:cubicBezTo>
                      <a:pt x="196789" y="292358"/>
                      <a:pt x="192128" y="312615"/>
                      <a:pt x="185615" y="332153"/>
                    </a:cubicBezTo>
                    <a:cubicBezTo>
                      <a:pt x="182359" y="341922"/>
                      <a:pt x="183128" y="354179"/>
                      <a:pt x="175846" y="361461"/>
                    </a:cubicBezTo>
                    <a:lnTo>
                      <a:pt x="156307" y="381000"/>
                    </a:lnTo>
                    <a:cubicBezTo>
                      <a:pt x="140713" y="427783"/>
                      <a:pt x="153820" y="403024"/>
                      <a:pt x="107461" y="449384"/>
                    </a:cubicBezTo>
                    <a:lnTo>
                      <a:pt x="87923" y="468923"/>
                    </a:lnTo>
                    <a:cubicBezTo>
                      <a:pt x="81410" y="488461"/>
                      <a:pt x="56960" y="510402"/>
                      <a:pt x="68384" y="527538"/>
                    </a:cubicBezTo>
                    <a:cubicBezTo>
                      <a:pt x="81410" y="547076"/>
                      <a:pt x="90857" y="569549"/>
                      <a:pt x="107461" y="586153"/>
                    </a:cubicBezTo>
                    <a:cubicBezTo>
                      <a:pt x="113974" y="592666"/>
                      <a:pt x="118762" y="601573"/>
                      <a:pt x="127000" y="605692"/>
                    </a:cubicBezTo>
                    <a:cubicBezTo>
                      <a:pt x="145421" y="614902"/>
                      <a:pt x="166077" y="618717"/>
                      <a:pt x="185615" y="625230"/>
                    </a:cubicBezTo>
                    <a:lnTo>
                      <a:pt x="214923" y="635000"/>
                    </a:lnTo>
                    <a:lnTo>
                      <a:pt x="244230" y="644769"/>
                    </a:lnTo>
                    <a:cubicBezTo>
                      <a:pt x="251940" y="667897"/>
                      <a:pt x="263769" y="699342"/>
                      <a:pt x="263769" y="722923"/>
                    </a:cubicBezTo>
                    <a:cubicBezTo>
                      <a:pt x="263769" y="749177"/>
                      <a:pt x="258697" y="775246"/>
                      <a:pt x="254000" y="801077"/>
                    </a:cubicBezTo>
                    <a:cubicBezTo>
                      <a:pt x="252158" y="811208"/>
                      <a:pt x="252609" y="824399"/>
                      <a:pt x="244230" y="830384"/>
                    </a:cubicBezTo>
                    <a:cubicBezTo>
                      <a:pt x="227471" y="842355"/>
                      <a:pt x="205153" y="843410"/>
                      <a:pt x="185615" y="849923"/>
                    </a:cubicBezTo>
                    <a:lnTo>
                      <a:pt x="156307" y="859692"/>
                    </a:lnTo>
                    <a:cubicBezTo>
                      <a:pt x="146538" y="866205"/>
                      <a:pt x="133223" y="869274"/>
                      <a:pt x="127000" y="879230"/>
                    </a:cubicBezTo>
                    <a:cubicBezTo>
                      <a:pt x="116084" y="896695"/>
                      <a:pt x="107461" y="937846"/>
                      <a:pt x="107461" y="937846"/>
                    </a:cubicBezTo>
                    <a:cubicBezTo>
                      <a:pt x="104205" y="973666"/>
                      <a:pt x="103943" y="1009886"/>
                      <a:pt x="97692" y="1045307"/>
                    </a:cubicBezTo>
                    <a:cubicBezTo>
                      <a:pt x="94113" y="1065589"/>
                      <a:pt x="84667" y="1084384"/>
                      <a:pt x="78154" y="1103923"/>
                    </a:cubicBezTo>
                    <a:lnTo>
                      <a:pt x="68384" y="1133230"/>
                    </a:lnTo>
                    <a:cubicBezTo>
                      <a:pt x="65128" y="1165794"/>
                      <a:pt x="62940" y="1198483"/>
                      <a:pt x="58615" y="1230923"/>
                    </a:cubicBezTo>
                    <a:cubicBezTo>
                      <a:pt x="48329" y="1308070"/>
                      <a:pt x="53165" y="1252727"/>
                      <a:pt x="39077" y="1309077"/>
                    </a:cubicBezTo>
                    <a:cubicBezTo>
                      <a:pt x="35050" y="1325186"/>
                      <a:pt x="32564" y="1341641"/>
                      <a:pt x="29307" y="1357923"/>
                    </a:cubicBezTo>
                    <a:cubicBezTo>
                      <a:pt x="32564" y="1377461"/>
                      <a:pt x="34780" y="1397202"/>
                      <a:pt x="39077" y="1416538"/>
                    </a:cubicBezTo>
                    <a:cubicBezTo>
                      <a:pt x="41311" y="1426591"/>
                      <a:pt x="48846" y="1435548"/>
                      <a:pt x="48846" y="1445846"/>
                    </a:cubicBezTo>
                    <a:cubicBezTo>
                      <a:pt x="48846" y="1454384"/>
                      <a:pt x="43047" y="1530407"/>
                      <a:pt x="29307" y="1553307"/>
                    </a:cubicBezTo>
                    <a:cubicBezTo>
                      <a:pt x="24568" y="1561205"/>
                      <a:pt x="16282" y="1566333"/>
                      <a:pt x="9769" y="1572846"/>
                    </a:cubicBezTo>
                    <a:cubicBezTo>
                      <a:pt x="6513" y="1598897"/>
                      <a:pt x="0" y="1624746"/>
                      <a:pt x="0" y="1651000"/>
                    </a:cubicBezTo>
                    <a:cubicBezTo>
                      <a:pt x="0" y="1721757"/>
                      <a:pt x="12102" y="1718508"/>
                      <a:pt x="19538" y="1778000"/>
                    </a:cubicBezTo>
                    <a:cubicBezTo>
                      <a:pt x="20750" y="1787694"/>
                      <a:pt x="19538" y="1797538"/>
                      <a:pt x="19538" y="1807307"/>
                    </a:cubicBezTo>
                  </a:path>
                </a:pathLst>
              </a:custGeom>
              <a:ln w="38100" cmpd="sng">
                <a:solidFill>
                  <a:srgbClr val="0D0D0D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9" name="TextBox 28"/>
            <p:cNvSpPr txBox="1"/>
            <p:nvPr/>
          </p:nvSpPr>
          <p:spPr>
            <a:xfrm>
              <a:off x="1686213" y="1146985"/>
              <a:ext cx="5707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PBS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749035" y="1125111"/>
              <a:ext cx="7810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AM/N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020115" y="1137783"/>
              <a:ext cx="7810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AM/H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2338404" y="3104504"/>
              <a:ext cx="2191714" cy="1829254"/>
              <a:chOff x="2338404" y="3104504"/>
              <a:chExt cx="2191714" cy="1829254"/>
            </a:xfrm>
          </p:grpSpPr>
          <p:pic>
            <p:nvPicPr>
              <p:cNvPr id="13" name="Picture 12" descr="PBS 1-3 ooo.jpg"/>
              <p:cNvPicPr>
                <a:picLocks noChangeAspect="1"/>
              </p:cNvPicPr>
              <p:nvPr/>
            </p:nvPicPr>
            <p:blipFill>
              <a:blip r:embed="rId12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38404" y="3104504"/>
                <a:ext cx="2191714" cy="1828800"/>
              </a:xfrm>
              <a:prstGeom prst="rect">
                <a:avLst/>
              </a:prstGeom>
            </p:spPr>
          </p:pic>
          <p:sp>
            <p:nvSpPr>
              <p:cNvPr id="32" name="Freeform 31"/>
              <p:cNvSpPr/>
              <p:nvPr/>
            </p:nvSpPr>
            <p:spPr>
              <a:xfrm>
                <a:off x="3255818" y="3109576"/>
                <a:ext cx="300182" cy="1816485"/>
              </a:xfrm>
              <a:custGeom>
                <a:avLst/>
                <a:gdLst>
                  <a:gd name="connsiteX0" fmla="*/ 146243 w 300182"/>
                  <a:gd name="connsiteY0" fmla="*/ 0 h 1816485"/>
                  <a:gd name="connsiteX1" fmla="*/ 161637 w 300182"/>
                  <a:gd name="connsiteY1" fmla="*/ 38485 h 1816485"/>
                  <a:gd name="connsiteX2" fmla="*/ 254000 w 300182"/>
                  <a:gd name="connsiteY2" fmla="*/ 84666 h 1816485"/>
                  <a:gd name="connsiteX3" fmla="*/ 300182 w 300182"/>
                  <a:gd name="connsiteY3" fmla="*/ 123151 h 1816485"/>
                  <a:gd name="connsiteX4" fmla="*/ 284788 w 300182"/>
                  <a:gd name="connsiteY4" fmla="*/ 230909 h 1816485"/>
                  <a:gd name="connsiteX5" fmla="*/ 269394 w 300182"/>
                  <a:gd name="connsiteY5" fmla="*/ 254000 h 1816485"/>
                  <a:gd name="connsiteX6" fmla="*/ 261697 w 300182"/>
                  <a:gd name="connsiteY6" fmla="*/ 277091 h 1816485"/>
                  <a:gd name="connsiteX7" fmla="*/ 238606 w 300182"/>
                  <a:gd name="connsiteY7" fmla="*/ 323272 h 1816485"/>
                  <a:gd name="connsiteX8" fmla="*/ 215515 w 300182"/>
                  <a:gd name="connsiteY8" fmla="*/ 415636 h 1816485"/>
                  <a:gd name="connsiteX9" fmla="*/ 200121 w 300182"/>
                  <a:gd name="connsiteY9" fmla="*/ 438727 h 1816485"/>
                  <a:gd name="connsiteX10" fmla="*/ 207818 w 300182"/>
                  <a:gd name="connsiteY10" fmla="*/ 508000 h 1816485"/>
                  <a:gd name="connsiteX11" fmla="*/ 230909 w 300182"/>
                  <a:gd name="connsiteY11" fmla="*/ 554182 h 1816485"/>
                  <a:gd name="connsiteX12" fmla="*/ 238606 w 300182"/>
                  <a:gd name="connsiteY12" fmla="*/ 577272 h 1816485"/>
                  <a:gd name="connsiteX13" fmla="*/ 215515 w 300182"/>
                  <a:gd name="connsiteY13" fmla="*/ 692727 h 1816485"/>
                  <a:gd name="connsiteX14" fmla="*/ 207818 w 300182"/>
                  <a:gd name="connsiteY14" fmla="*/ 715818 h 1816485"/>
                  <a:gd name="connsiteX15" fmla="*/ 192424 w 300182"/>
                  <a:gd name="connsiteY15" fmla="*/ 738909 h 1816485"/>
                  <a:gd name="connsiteX16" fmla="*/ 169334 w 300182"/>
                  <a:gd name="connsiteY16" fmla="*/ 808182 h 1816485"/>
                  <a:gd name="connsiteX17" fmla="*/ 161637 w 300182"/>
                  <a:gd name="connsiteY17" fmla="*/ 831272 h 1816485"/>
                  <a:gd name="connsiteX18" fmla="*/ 184727 w 300182"/>
                  <a:gd name="connsiteY18" fmla="*/ 923636 h 1816485"/>
                  <a:gd name="connsiteX19" fmla="*/ 192424 w 300182"/>
                  <a:gd name="connsiteY19" fmla="*/ 946727 h 1816485"/>
                  <a:gd name="connsiteX20" fmla="*/ 153940 w 300182"/>
                  <a:gd name="connsiteY20" fmla="*/ 1016000 h 1816485"/>
                  <a:gd name="connsiteX21" fmla="*/ 130849 w 300182"/>
                  <a:gd name="connsiteY21" fmla="*/ 1023697 h 1816485"/>
                  <a:gd name="connsiteX22" fmla="*/ 107758 w 300182"/>
                  <a:gd name="connsiteY22" fmla="*/ 1046788 h 1816485"/>
                  <a:gd name="connsiteX23" fmla="*/ 84667 w 300182"/>
                  <a:gd name="connsiteY23" fmla="*/ 1054485 h 1816485"/>
                  <a:gd name="connsiteX24" fmla="*/ 76970 w 300182"/>
                  <a:gd name="connsiteY24" fmla="*/ 1077576 h 1816485"/>
                  <a:gd name="connsiteX25" fmla="*/ 61576 w 300182"/>
                  <a:gd name="connsiteY25" fmla="*/ 1100666 h 1816485"/>
                  <a:gd name="connsiteX26" fmla="*/ 46182 w 300182"/>
                  <a:gd name="connsiteY26" fmla="*/ 1200727 h 1816485"/>
                  <a:gd name="connsiteX27" fmla="*/ 30788 w 300182"/>
                  <a:gd name="connsiteY27" fmla="*/ 1270000 h 1816485"/>
                  <a:gd name="connsiteX28" fmla="*/ 38485 w 300182"/>
                  <a:gd name="connsiteY28" fmla="*/ 1308485 h 1816485"/>
                  <a:gd name="connsiteX29" fmla="*/ 53879 w 300182"/>
                  <a:gd name="connsiteY29" fmla="*/ 1354666 h 1816485"/>
                  <a:gd name="connsiteX30" fmla="*/ 61576 w 300182"/>
                  <a:gd name="connsiteY30" fmla="*/ 1393151 h 1816485"/>
                  <a:gd name="connsiteX31" fmla="*/ 38485 w 300182"/>
                  <a:gd name="connsiteY31" fmla="*/ 1493212 h 1816485"/>
                  <a:gd name="connsiteX32" fmla="*/ 30788 w 300182"/>
                  <a:gd name="connsiteY32" fmla="*/ 1516303 h 1816485"/>
                  <a:gd name="connsiteX33" fmla="*/ 15394 w 300182"/>
                  <a:gd name="connsiteY33" fmla="*/ 1539394 h 1816485"/>
                  <a:gd name="connsiteX34" fmla="*/ 0 w 300182"/>
                  <a:gd name="connsiteY34" fmla="*/ 1585576 h 1816485"/>
                  <a:gd name="connsiteX35" fmla="*/ 7697 w 300182"/>
                  <a:gd name="connsiteY35" fmla="*/ 1701030 h 1816485"/>
                  <a:gd name="connsiteX36" fmla="*/ 23091 w 300182"/>
                  <a:gd name="connsiteY36" fmla="*/ 1785697 h 1816485"/>
                  <a:gd name="connsiteX37" fmla="*/ 46182 w 300182"/>
                  <a:gd name="connsiteY37" fmla="*/ 1816485 h 18164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</a:cxnLst>
                <a:rect l="l" t="t" r="r" b="b"/>
                <a:pathLst>
                  <a:path w="300182" h="1816485">
                    <a:moveTo>
                      <a:pt x="146243" y="0"/>
                    </a:moveTo>
                    <a:cubicBezTo>
                      <a:pt x="151374" y="12828"/>
                      <a:pt x="152458" y="28158"/>
                      <a:pt x="161637" y="38485"/>
                    </a:cubicBezTo>
                    <a:cubicBezTo>
                      <a:pt x="214483" y="97937"/>
                      <a:pt x="196262" y="46174"/>
                      <a:pt x="254000" y="84666"/>
                    </a:cubicBezTo>
                    <a:cubicBezTo>
                      <a:pt x="286148" y="106098"/>
                      <a:pt x="270550" y="93519"/>
                      <a:pt x="300182" y="123151"/>
                    </a:cubicBezTo>
                    <a:cubicBezTo>
                      <a:pt x="298825" y="136725"/>
                      <a:pt x="295706" y="205434"/>
                      <a:pt x="284788" y="230909"/>
                    </a:cubicBezTo>
                    <a:cubicBezTo>
                      <a:pt x="281144" y="239412"/>
                      <a:pt x="273531" y="245726"/>
                      <a:pt x="269394" y="254000"/>
                    </a:cubicBezTo>
                    <a:cubicBezTo>
                      <a:pt x="265766" y="261257"/>
                      <a:pt x="265325" y="269834"/>
                      <a:pt x="261697" y="277091"/>
                    </a:cubicBezTo>
                    <a:cubicBezTo>
                      <a:pt x="231854" y="336776"/>
                      <a:pt x="257953" y="265232"/>
                      <a:pt x="238606" y="323272"/>
                    </a:cubicBezTo>
                    <a:cubicBezTo>
                      <a:pt x="234759" y="346356"/>
                      <a:pt x="229068" y="395307"/>
                      <a:pt x="215515" y="415636"/>
                    </a:cubicBezTo>
                    <a:lnTo>
                      <a:pt x="200121" y="438727"/>
                    </a:lnTo>
                    <a:cubicBezTo>
                      <a:pt x="202687" y="461818"/>
                      <a:pt x="203999" y="485083"/>
                      <a:pt x="207818" y="508000"/>
                    </a:cubicBezTo>
                    <a:cubicBezTo>
                      <a:pt x="212655" y="537019"/>
                      <a:pt x="217611" y="527587"/>
                      <a:pt x="230909" y="554182"/>
                    </a:cubicBezTo>
                    <a:cubicBezTo>
                      <a:pt x="234537" y="561438"/>
                      <a:pt x="236040" y="569575"/>
                      <a:pt x="238606" y="577272"/>
                    </a:cubicBezTo>
                    <a:cubicBezTo>
                      <a:pt x="229117" y="662672"/>
                      <a:pt x="238256" y="624504"/>
                      <a:pt x="215515" y="692727"/>
                    </a:cubicBezTo>
                    <a:cubicBezTo>
                      <a:pt x="212949" y="700424"/>
                      <a:pt x="212318" y="709067"/>
                      <a:pt x="207818" y="715818"/>
                    </a:cubicBezTo>
                    <a:cubicBezTo>
                      <a:pt x="202687" y="723515"/>
                      <a:pt x="196181" y="730456"/>
                      <a:pt x="192424" y="738909"/>
                    </a:cubicBezTo>
                    <a:cubicBezTo>
                      <a:pt x="192412" y="738936"/>
                      <a:pt x="173187" y="796622"/>
                      <a:pt x="169334" y="808182"/>
                    </a:cubicBezTo>
                    <a:lnTo>
                      <a:pt x="161637" y="831272"/>
                    </a:lnTo>
                    <a:cubicBezTo>
                      <a:pt x="172001" y="893457"/>
                      <a:pt x="164400" y="862651"/>
                      <a:pt x="184727" y="923636"/>
                    </a:cubicBezTo>
                    <a:lnTo>
                      <a:pt x="192424" y="946727"/>
                    </a:lnTo>
                    <a:cubicBezTo>
                      <a:pt x="180949" y="981151"/>
                      <a:pt x="183566" y="996249"/>
                      <a:pt x="153940" y="1016000"/>
                    </a:cubicBezTo>
                    <a:cubicBezTo>
                      <a:pt x="147189" y="1020501"/>
                      <a:pt x="138546" y="1021131"/>
                      <a:pt x="130849" y="1023697"/>
                    </a:cubicBezTo>
                    <a:cubicBezTo>
                      <a:pt x="123152" y="1031394"/>
                      <a:pt x="116815" y="1040750"/>
                      <a:pt x="107758" y="1046788"/>
                    </a:cubicBezTo>
                    <a:cubicBezTo>
                      <a:pt x="101007" y="1051288"/>
                      <a:pt x="90404" y="1048748"/>
                      <a:pt x="84667" y="1054485"/>
                    </a:cubicBezTo>
                    <a:cubicBezTo>
                      <a:pt x="78930" y="1060222"/>
                      <a:pt x="80598" y="1070319"/>
                      <a:pt x="76970" y="1077576"/>
                    </a:cubicBezTo>
                    <a:cubicBezTo>
                      <a:pt x="72833" y="1085850"/>
                      <a:pt x="66707" y="1092969"/>
                      <a:pt x="61576" y="1100666"/>
                    </a:cubicBezTo>
                    <a:cubicBezTo>
                      <a:pt x="44655" y="1151430"/>
                      <a:pt x="58088" y="1105479"/>
                      <a:pt x="46182" y="1200727"/>
                    </a:cubicBezTo>
                    <a:cubicBezTo>
                      <a:pt x="40764" y="1244075"/>
                      <a:pt x="41542" y="1237737"/>
                      <a:pt x="30788" y="1270000"/>
                    </a:cubicBezTo>
                    <a:cubicBezTo>
                      <a:pt x="33354" y="1282828"/>
                      <a:pt x="35043" y="1295864"/>
                      <a:pt x="38485" y="1308485"/>
                    </a:cubicBezTo>
                    <a:cubicBezTo>
                      <a:pt x="42754" y="1324140"/>
                      <a:pt x="50697" y="1338755"/>
                      <a:pt x="53879" y="1354666"/>
                    </a:cubicBezTo>
                    <a:lnTo>
                      <a:pt x="61576" y="1393151"/>
                    </a:lnTo>
                    <a:cubicBezTo>
                      <a:pt x="51584" y="1463094"/>
                      <a:pt x="59616" y="1429819"/>
                      <a:pt x="38485" y="1493212"/>
                    </a:cubicBezTo>
                    <a:cubicBezTo>
                      <a:pt x="35919" y="1500909"/>
                      <a:pt x="35288" y="1509552"/>
                      <a:pt x="30788" y="1516303"/>
                    </a:cubicBezTo>
                    <a:cubicBezTo>
                      <a:pt x="25657" y="1524000"/>
                      <a:pt x="19151" y="1530941"/>
                      <a:pt x="15394" y="1539394"/>
                    </a:cubicBezTo>
                    <a:cubicBezTo>
                      <a:pt x="8804" y="1554222"/>
                      <a:pt x="0" y="1585576"/>
                      <a:pt x="0" y="1585576"/>
                    </a:cubicBezTo>
                    <a:cubicBezTo>
                      <a:pt x="2566" y="1624061"/>
                      <a:pt x="4356" y="1662605"/>
                      <a:pt x="7697" y="1701030"/>
                    </a:cubicBezTo>
                    <a:cubicBezTo>
                      <a:pt x="9373" y="1720301"/>
                      <a:pt x="11609" y="1762734"/>
                      <a:pt x="23091" y="1785697"/>
                    </a:cubicBezTo>
                    <a:cubicBezTo>
                      <a:pt x="31794" y="1803104"/>
                      <a:pt x="35358" y="1805661"/>
                      <a:pt x="46182" y="1816485"/>
                    </a:cubicBezTo>
                  </a:path>
                </a:pathLst>
              </a:custGeom>
              <a:ln w="38100" cmpd="sng">
                <a:solidFill>
                  <a:srgbClr val="0D0D0D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Freeform 33"/>
              <p:cNvSpPr/>
              <p:nvPr/>
            </p:nvSpPr>
            <p:spPr>
              <a:xfrm>
                <a:off x="2755515" y="3117273"/>
                <a:ext cx="315576" cy="1816485"/>
              </a:xfrm>
              <a:custGeom>
                <a:avLst/>
                <a:gdLst>
                  <a:gd name="connsiteX0" fmla="*/ 315576 w 315576"/>
                  <a:gd name="connsiteY0" fmla="*/ 0 h 1816485"/>
                  <a:gd name="connsiteX1" fmla="*/ 292485 w 315576"/>
                  <a:gd name="connsiteY1" fmla="*/ 38485 h 1816485"/>
                  <a:gd name="connsiteX2" fmla="*/ 269394 w 315576"/>
                  <a:gd name="connsiteY2" fmla="*/ 92363 h 1816485"/>
                  <a:gd name="connsiteX3" fmla="*/ 246303 w 315576"/>
                  <a:gd name="connsiteY3" fmla="*/ 169333 h 1816485"/>
                  <a:gd name="connsiteX4" fmla="*/ 238606 w 315576"/>
                  <a:gd name="connsiteY4" fmla="*/ 192424 h 1816485"/>
                  <a:gd name="connsiteX5" fmla="*/ 230909 w 315576"/>
                  <a:gd name="connsiteY5" fmla="*/ 246303 h 1816485"/>
                  <a:gd name="connsiteX6" fmla="*/ 223212 w 315576"/>
                  <a:gd name="connsiteY6" fmla="*/ 292485 h 1816485"/>
                  <a:gd name="connsiteX7" fmla="*/ 207818 w 315576"/>
                  <a:gd name="connsiteY7" fmla="*/ 469515 h 1816485"/>
                  <a:gd name="connsiteX8" fmla="*/ 177030 w 315576"/>
                  <a:gd name="connsiteY8" fmla="*/ 538788 h 1816485"/>
                  <a:gd name="connsiteX9" fmla="*/ 169333 w 315576"/>
                  <a:gd name="connsiteY9" fmla="*/ 561879 h 1816485"/>
                  <a:gd name="connsiteX10" fmla="*/ 138546 w 315576"/>
                  <a:gd name="connsiteY10" fmla="*/ 608060 h 1816485"/>
                  <a:gd name="connsiteX11" fmla="*/ 123152 w 315576"/>
                  <a:gd name="connsiteY11" fmla="*/ 631151 h 1816485"/>
                  <a:gd name="connsiteX12" fmla="*/ 92364 w 315576"/>
                  <a:gd name="connsiteY12" fmla="*/ 708121 h 1816485"/>
                  <a:gd name="connsiteX13" fmla="*/ 84667 w 315576"/>
                  <a:gd name="connsiteY13" fmla="*/ 731212 h 1816485"/>
                  <a:gd name="connsiteX14" fmla="*/ 69273 w 315576"/>
                  <a:gd name="connsiteY14" fmla="*/ 754303 h 1816485"/>
                  <a:gd name="connsiteX15" fmla="*/ 53879 w 315576"/>
                  <a:gd name="connsiteY15" fmla="*/ 800485 h 1816485"/>
                  <a:gd name="connsiteX16" fmla="*/ 30788 w 315576"/>
                  <a:gd name="connsiteY16" fmla="*/ 869757 h 1816485"/>
                  <a:gd name="connsiteX17" fmla="*/ 7697 w 315576"/>
                  <a:gd name="connsiteY17" fmla="*/ 939030 h 1816485"/>
                  <a:gd name="connsiteX18" fmla="*/ 0 w 315576"/>
                  <a:gd name="connsiteY18" fmla="*/ 962121 h 1816485"/>
                  <a:gd name="connsiteX19" fmla="*/ 7697 w 315576"/>
                  <a:gd name="connsiteY19" fmla="*/ 1131454 h 1816485"/>
                  <a:gd name="connsiteX20" fmla="*/ 61576 w 315576"/>
                  <a:gd name="connsiteY20" fmla="*/ 1185333 h 1816485"/>
                  <a:gd name="connsiteX21" fmla="*/ 84667 w 315576"/>
                  <a:gd name="connsiteY21" fmla="*/ 1200727 h 1816485"/>
                  <a:gd name="connsiteX22" fmla="*/ 115455 w 315576"/>
                  <a:gd name="connsiteY22" fmla="*/ 1208424 h 1816485"/>
                  <a:gd name="connsiteX23" fmla="*/ 169333 w 315576"/>
                  <a:gd name="connsiteY23" fmla="*/ 1223818 h 1816485"/>
                  <a:gd name="connsiteX24" fmla="*/ 184727 w 315576"/>
                  <a:gd name="connsiteY24" fmla="*/ 1246909 h 1816485"/>
                  <a:gd name="connsiteX25" fmla="*/ 192424 w 315576"/>
                  <a:gd name="connsiteY25" fmla="*/ 1270000 h 1816485"/>
                  <a:gd name="connsiteX26" fmla="*/ 223212 w 315576"/>
                  <a:gd name="connsiteY26" fmla="*/ 1316182 h 1816485"/>
                  <a:gd name="connsiteX27" fmla="*/ 230909 w 315576"/>
                  <a:gd name="connsiteY27" fmla="*/ 1339272 h 1816485"/>
                  <a:gd name="connsiteX28" fmla="*/ 269394 w 315576"/>
                  <a:gd name="connsiteY28" fmla="*/ 1408545 h 1816485"/>
                  <a:gd name="connsiteX29" fmla="*/ 246303 w 315576"/>
                  <a:gd name="connsiteY29" fmla="*/ 1547091 h 1816485"/>
                  <a:gd name="connsiteX30" fmla="*/ 238606 w 315576"/>
                  <a:gd name="connsiteY30" fmla="*/ 1570182 h 1816485"/>
                  <a:gd name="connsiteX31" fmla="*/ 230909 w 315576"/>
                  <a:gd name="connsiteY31" fmla="*/ 1593272 h 1816485"/>
                  <a:gd name="connsiteX32" fmla="*/ 223212 w 315576"/>
                  <a:gd name="connsiteY32" fmla="*/ 1670242 h 1816485"/>
                  <a:gd name="connsiteX33" fmla="*/ 215515 w 315576"/>
                  <a:gd name="connsiteY33" fmla="*/ 1708727 h 1816485"/>
                  <a:gd name="connsiteX34" fmla="*/ 215515 w 315576"/>
                  <a:gd name="connsiteY34" fmla="*/ 1816485 h 18164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315576" h="1816485">
                    <a:moveTo>
                      <a:pt x="315576" y="0"/>
                    </a:moveTo>
                    <a:cubicBezTo>
                      <a:pt x="307879" y="12828"/>
                      <a:pt x="298561" y="24814"/>
                      <a:pt x="292485" y="38485"/>
                    </a:cubicBezTo>
                    <a:cubicBezTo>
                      <a:pt x="259350" y="113038"/>
                      <a:pt x="310939" y="30045"/>
                      <a:pt x="269394" y="92363"/>
                    </a:cubicBezTo>
                    <a:cubicBezTo>
                      <a:pt x="257761" y="138893"/>
                      <a:pt x="265042" y="113115"/>
                      <a:pt x="246303" y="169333"/>
                    </a:cubicBezTo>
                    <a:lnTo>
                      <a:pt x="238606" y="192424"/>
                    </a:lnTo>
                    <a:cubicBezTo>
                      <a:pt x="236040" y="210384"/>
                      <a:pt x="233668" y="228372"/>
                      <a:pt x="230909" y="246303"/>
                    </a:cubicBezTo>
                    <a:cubicBezTo>
                      <a:pt x="228536" y="261728"/>
                      <a:pt x="224457" y="276928"/>
                      <a:pt x="223212" y="292485"/>
                    </a:cubicBezTo>
                    <a:cubicBezTo>
                      <a:pt x="215663" y="386842"/>
                      <a:pt x="227202" y="404903"/>
                      <a:pt x="207818" y="469515"/>
                    </a:cubicBezTo>
                    <a:cubicBezTo>
                      <a:pt x="178032" y="568803"/>
                      <a:pt x="207962" y="476924"/>
                      <a:pt x="177030" y="538788"/>
                    </a:cubicBezTo>
                    <a:cubicBezTo>
                      <a:pt x="173402" y="546045"/>
                      <a:pt x="173273" y="554787"/>
                      <a:pt x="169333" y="561879"/>
                    </a:cubicBezTo>
                    <a:cubicBezTo>
                      <a:pt x="160348" y="578052"/>
                      <a:pt x="148808" y="592666"/>
                      <a:pt x="138546" y="608060"/>
                    </a:cubicBezTo>
                    <a:cubicBezTo>
                      <a:pt x="133415" y="615757"/>
                      <a:pt x="126077" y="622375"/>
                      <a:pt x="123152" y="631151"/>
                    </a:cubicBezTo>
                    <a:cubicBezTo>
                      <a:pt x="88113" y="736268"/>
                      <a:pt x="126340" y="628843"/>
                      <a:pt x="92364" y="708121"/>
                    </a:cubicBezTo>
                    <a:cubicBezTo>
                      <a:pt x="89168" y="715578"/>
                      <a:pt x="88295" y="723955"/>
                      <a:pt x="84667" y="731212"/>
                    </a:cubicBezTo>
                    <a:cubicBezTo>
                      <a:pt x="80530" y="739486"/>
                      <a:pt x="73030" y="745850"/>
                      <a:pt x="69273" y="754303"/>
                    </a:cubicBezTo>
                    <a:cubicBezTo>
                      <a:pt x="62683" y="769131"/>
                      <a:pt x="59010" y="785091"/>
                      <a:pt x="53879" y="800485"/>
                    </a:cubicBezTo>
                    <a:lnTo>
                      <a:pt x="30788" y="869757"/>
                    </a:lnTo>
                    <a:lnTo>
                      <a:pt x="7697" y="939030"/>
                    </a:lnTo>
                    <a:lnTo>
                      <a:pt x="0" y="962121"/>
                    </a:lnTo>
                    <a:cubicBezTo>
                      <a:pt x="2566" y="1018565"/>
                      <a:pt x="3191" y="1075131"/>
                      <a:pt x="7697" y="1131454"/>
                    </a:cubicBezTo>
                    <a:cubicBezTo>
                      <a:pt x="10368" y="1164846"/>
                      <a:pt x="33445" y="1166579"/>
                      <a:pt x="61576" y="1185333"/>
                    </a:cubicBezTo>
                    <a:cubicBezTo>
                      <a:pt x="69273" y="1190464"/>
                      <a:pt x="75693" y="1198483"/>
                      <a:pt x="84667" y="1200727"/>
                    </a:cubicBezTo>
                    <a:cubicBezTo>
                      <a:pt x="94930" y="1203293"/>
                      <a:pt x="105284" y="1205518"/>
                      <a:pt x="115455" y="1208424"/>
                    </a:cubicBezTo>
                    <a:cubicBezTo>
                      <a:pt x="192760" y="1230511"/>
                      <a:pt x="73075" y="1199753"/>
                      <a:pt x="169333" y="1223818"/>
                    </a:cubicBezTo>
                    <a:cubicBezTo>
                      <a:pt x="174464" y="1231515"/>
                      <a:pt x="180590" y="1238635"/>
                      <a:pt x="184727" y="1246909"/>
                    </a:cubicBezTo>
                    <a:cubicBezTo>
                      <a:pt x="188355" y="1254166"/>
                      <a:pt x="188484" y="1262908"/>
                      <a:pt x="192424" y="1270000"/>
                    </a:cubicBezTo>
                    <a:cubicBezTo>
                      <a:pt x="201409" y="1286173"/>
                      <a:pt x="217361" y="1298630"/>
                      <a:pt x="223212" y="1316182"/>
                    </a:cubicBezTo>
                    <a:cubicBezTo>
                      <a:pt x="225778" y="1323879"/>
                      <a:pt x="226969" y="1332180"/>
                      <a:pt x="230909" y="1339272"/>
                    </a:cubicBezTo>
                    <a:cubicBezTo>
                      <a:pt x="275019" y="1418668"/>
                      <a:pt x="251978" y="1356297"/>
                      <a:pt x="269394" y="1408545"/>
                    </a:cubicBezTo>
                    <a:cubicBezTo>
                      <a:pt x="260349" y="1517080"/>
                      <a:pt x="271467" y="1471600"/>
                      <a:pt x="246303" y="1547091"/>
                    </a:cubicBezTo>
                    <a:lnTo>
                      <a:pt x="238606" y="1570182"/>
                    </a:lnTo>
                    <a:lnTo>
                      <a:pt x="230909" y="1593272"/>
                    </a:lnTo>
                    <a:cubicBezTo>
                      <a:pt x="228343" y="1618929"/>
                      <a:pt x="226620" y="1644684"/>
                      <a:pt x="223212" y="1670242"/>
                    </a:cubicBezTo>
                    <a:cubicBezTo>
                      <a:pt x="221483" y="1683210"/>
                      <a:pt x="216203" y="1695663"/>
                      <a:pt x="215515" y="1708727"/>
                    </a:cubicBezTo>
                    <a:cubicBezTo>
                      <a:pt x="213627" y="1744597"/>
                      <a:pt x="215515" y="1780566"/>
                      <a:pt x="215515" y="1816485"/>
                    </a:cubicBezTo>
                  </a:path>
                </a:pathLst>
              </a:custGeom>
              <a:ln w="38100" cmpd="sng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78013" y="1125111"/>
              <a:ext cx="4638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Palatino Linotype"/>
                  <a:cs typeface="Palatino Linotype"/>
                </a:rPr>
                <a:t>0 h</a:t>
              </a:r>
              <a:endParaRPr lang="en-US" sz="1600" b="1" dirty="0">
                <a:solidFill>
                  <a:schemeClr val="bg1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07756" y="3111288"/>
              <a:ext cx="5664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Palatino Linotype"/>
                  <a:cs typeface="Palatino Linotype"/>
                </a:rPr>
                <a:t>24 h</a:t>
              </a:r>
              <a:endParaRPr lang="en-US" sz="1600" b="1" dirty="0">
                <a:solidFill>
                  <a:schemeClr val="bg1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686213" y="3117273"/>
              <a:ext cx="5707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PBS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749035" y="3095399"/>
              <a:ext cx="7810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AM/N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020115" y="3108071"/>
              <a:ext cx="7810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rgbClr val="FFFFFF"/>
                  </a:solidFill>
                  <a:latin typeface="Palatino Linotype"/>
                  <a:cs typeface="Palatino Linotype"/>
                </a:rPr>
                <a:t>AM/H</a:t>
              </a:r>
              <a:endParaRPr lang="en-US" sz="1600" b="1" dirty="0">
                <a:solidFill>
                  <a:srgbClr val="FFFFFF"/>
                </a:solidFill>
                <a:latin typeface="Palatino Linotype"/>
                <a:cs typeface="Palatino Linotype"/>
              </a:endParaRPr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6503101" y="4818346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4240683" y="4818346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2009692" y="4818346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6503101" y="2848461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4240683" y="2848461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2009692" y="2848461"/>
              <a:ext cx="181429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6160373" y="4534260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chemeClr val="bg1"/>
                  </a:solidFill>
                  <a:latin typeface="Palatino Linotype"/>
                  <a:cs typeface="Palatino Linotype"/>
                </a:rPr>
                <a:t>200 </a:t>
              </a:r>
              <a:r>
                <a:rPr lang="en-US" sz="1200" b="1" dirty="0" err="1" smtClean="0">
                  <a:solidFill>
                    <a:schemeClr val="bg1"/>
                  </a:solidFill>
                  <a:latin typeface="Palatino Linotype"/>
                  <a:cs typeface="Palatino Linotype"/>
                </a:rPr>
                <a:t>μm</a:t>
              </a:r>
              <a:endParaRPr lang="en-US" sz="1200" b="1" dirty="0">
                <a:solidFill>
                  <a:schemeClr val="bg1"/>
                </a:solidFill>
                <a:latin typeface="Palatino Linotype"/>
                <a:cs typeface="Palatino Linotype"/>
              </a:endParaRPr>
            </a:p>
          </p:txBody>
        </p:sp>
      </p:grpSp>
      <p:sp>
        <p:nvSpPr>
          <p:cNvPr id="51" name="Rectangle 50"/>
          <p:cNvSpPr/>
          <p:nvPr/>
        </p:nvSpPr>
        <p:spPr>
          <a:xfrm>
            <a:off x="0" y="12932"/>
            <a:ext cx="25531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Supplemental Figure </a:t>
            </a:r>
            <a:r>
              <a:rPr lang="en-US" b="1" dirty="0" smtClean="0">
                <a:latin typeface="Times New Roman"/>
                <a:cs typeface="Times New Roman"/>
              </a:rPr>
              <a:t>S2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>
            <a:off x="183050" y="5219372"/>
            <a:ext cx="650148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Supplemental Figure </a:t>
            </a:r>
            <a:r>
              <a:rPr lang="en-US" b="1" dirty="0" smtClean="0">
                <a:latin typeface="Times New Roman"/>
                <a:cs typeface="Times New Roman"/>
              </a:rPr>
              <a:t>S2</a:t>
            </a:r>
            <a:r>
              <a:rPr lang="en-US" dirty="0" smtClean="0">
                <a:latin typeface="Times New Roman"/>
                <a:cs typeface="Times New Roman"/>
              </a:rPr>
              <a:t>. </a:t>
            </a:r>
            <a:r>
              <a:rPr lang="en-US" dirty="0">
                <a:latin typeface="Times New Roman"/>
                <a:cs typeface="Times New Roman"/>
              </a:rPr>
              <a:t>Effect of AM exosomes on the migration of LX-2 cells in a scratch wound assay.  LX-2 cells were cultured to confluence. </a:t>
            </a:r>
            <a:r>
              <a:rPr lang="en-US" dirty="0">
                <a:latin typeface="Times New Roman"/>
                <a:cs typeface="Times New Roman"/>
              </a:rPr>
              <a:t>A scratch wound was created and images were captured at time </a:t>
            </a:r>
            <a:r>
              <a:rPr lang="en-US" dirty="0" smtClean="0">
                <a:latin typeface="Times New Roman"/>
                <a:cs typeface="Times New Roman"/>
              </a:rPr>
              <a:t>0 h. </a:t>
            </a:r>
            <a:r>
              <a:rPr lang="en-US" dirty="0">
                <a:latin typeface="Times New Roman"/>
                <a:cs typeface="Times New Roman"/>
              </a:rPr>
              <a:t>After incubation with PBS or exosomes for 24 h, the wound areas were imaged. </a:t>
            </a:r>
            <a:r>
              <a:rPr lang="en-US" dirty="0">
                <a:latin typeface="Times New Roman"/>
                <a:cs typeface="Times New Roman"/>
              </a:rPr>
              <a:t>Representative images were </a:t>
            </a:r>
            <a:r>
              <a:rPr lang="en-US" dirty="0" smtClean="0">
                <a:latin typeface="Times New Roman"/>
                <a:cs typeface="Times New Roman"/>
              </a:rPr>
              <a:t>shown and the edges of the wounds are marked by black dotted lines. </a:t>
            </a:r>
            <a:r>
              <a:rPr lang="en-US" dirty="0" smtClean="0">
                <a:latin typeface="Times New Roman"/>
                <a:cs typeface="Times New Roman"/>
              </a:rPr>
              <a:t>Scale bar=200 </a:t>
            </a:r>
            <a:r>
              <a:rPr lang="en-US" dirty="0" err="1" smtClean="0">
                <a:latin typeface="Times New Roman"/>
                <a:cs typeface="Times New Roman"/>
              </a:rPr>
              <a:t>μm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88523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82</Words>
  <Application>Microsoft Macintosh PowerPoint</Application>
  <PresentationFormat>On-screen Show (4:3)</PresentationFormat>
  <Paragraphs>2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NJCBM - Rutgers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ng Mao</dc:creator>
  <cp:lastModifiedBy>Yong Mao</cp:lastModifiedBy>
  <cp:revision>6</cp:revision>
  <dcterms:created xsi:type="dcterms:W3CDTF">2021-02-07T18:46:15Z</dcterms:created>
  <dcterms:modified xsi:type="dcterms:W3CDTF">2021-02-08T20:26:12Z</dcterms:modified>
</cp:coreProperties>
</file>